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8"/>
  </p:notesMasterIdLst>
  <p:sldIdLst>
    <p:sldId id="257" r:id="rId2"/>
    <p:sldId id="434" r:id="rId3"/>
    <p:sldId id="430" r:id="rId4"/>
    <p:sldId id="435" r:id="rId5"/>
    <p:sldId id="414" r:id="rId6"/>
    <p:sldId id="436" r:id="rId7"/>
    <p:sldId id="415" r:id="rId8"/>
    <p:sldId id="437" r:id="rId9"/>
    <p:sldId id="433" r:id="rId10"/>
    <p:sldId id="438" r:id="rId11"/>
    <p:sldId id="411" r:id="rId12"/>
    <p:sldId id="439" r:id="rId13"/>
    <p:sldId id="266" r:id="rId14"/>
    <p:sldId id="440" r:id="rId15"/>
    <p:sldId id="412" r:id="rId16"/>
    <p:sldId id="441" r:id="rId17"/>
    <p:sldId id="408" r:id="rId18"/>
    <p:sldId id="442" r:id="rId19"/>
    <p:sldId id="432" r:id="rId20"/>
    <p:sldId id="443" r:id="rId21"/>
    <p:sldId id="358" r:id="rId22"/>
    <p:sldId id="444" r:id="rId23"/>
    <p:sldId id="362" r:id="rId24"/>
    <p:sldId id="445" r:id="rId25"/>
    <p:sldId id="363" r:id="rId26"/>
    <p:sldId id="446" r:id="rId2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451" autoAdjust="0"/>
  </p:normalViewPr>
  <p:slideViewPr>
    <p:cSldViewPr snapToGrid="0">
      <p:cViewPr varScale="1">
        <p:scale>
          <a:sx n="81" d="100"/>
          <a:sy n="81" d="100"/>
        </p:scale>
        <p:origin x="1263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C2F242-4E34-45AB-9CBB-44DBB374D41D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5137B1-C6A3-45C6-9441-6ABCBF9C87E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2422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5137B1-C6A3-45C6-9441-6ABCBF9C87E3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01416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5137B1-C6A3-45C6-9441-6ABCBF9C87E3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14205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5137B1-C6A3-45C6-9441-6ABCBF9C87E3}" type="slidenum">
              <a:rPr lang="zh-CN" altLang="en-US" smtClean="0"/>
              <a:t>1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66083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7445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140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8092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23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2860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552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55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6529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852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437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7622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58FCC-F096-46C6-A83F-C8AF08A1DFC6}" type="datetimeFigureOut">
              <a:rPr lang="zh-CN" altLang="en-US" smtClean="0"/>
              <a:t>2023/6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85AB6-565C-4048-AF22-EC3C45CCC1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4197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7" Type="http://schemas.openxmlformats.org/officeDocument/2006/relationships/image" Target="../media/image36.png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12" Type="http://schemas.openxmlformats.org/officeDocument/2006/relationships/image" Target="../media/image47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emf"/><Relationship Id="rId11" Type="http://schemas.openxmlformats.org/officeDocument/2006/relationships/image" Target="../media/image46.emf"/><Relationship Id="rId5" Type="http://schemas.openxmlformats.org/officeDocument/2006/relationships/image" Target="../media/image40.png"/><Relationship Id="rId10" Type="http://schemas.openxmlformats.org/officeDocument/2006/relationships/image" Target="../media/image45.emf"/><Relationship Id="rId4" Type="http://schemas.openxmlformats.org/officeDocument/2006/relationships/image" Target="../media/image39.emf"/><Relationship Id="rId9" Type="http://schemas.openxmlformats.org/officeDocument/2006/relationships/image" Target="../media/image44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7" Type="http://schemas.openxmlformats.org/officeDocument/2006/relationships/image" Target="../media/image5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emf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5" Type="http://schemas.openxmlformats.org/officeDocument/2006/relationships/image" Target="../media/image60.emf"/><Relationship Id="rId4" Type="http://schemas.openxmlformats.org/officeDocument/2006/relationships/image" Target="../media/image59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pn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png"/><Relationship Id="rId7" Type="http://schemas.openxmlformats.org/officeDocument/2006/relationships/image" Target="../media/image16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58146" y="5968169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 Establishment of the d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-p300 knock-in HEK293T cell line.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412088" y="652375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412087" y="3302105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250922" y="3302105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2105014" y="3599847"/>
            <a:ext cx="1913008" cy="1924685"/>
            <a:chOff x="2204697" y="3599847"/>
            <a:chExt cx="1913008" cy="1924685"/>
          </a:xfrm>
        </p:grpSpPr>
        <p:sp>
          <p:nvSpPr>
            <p:cNvPr id="22" name="文本框 21"/>
            <p:cNvSpPr txBox="1"/>
            <p:nvPr/>
          </p:nvSpPr>
          <p:spPr>
            <a:xfrm>
              <a:off x="2383292" y="5167102"/>
              <a:ext cx="575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zh-CN" altLang="en-US" sz="10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383292" y="4803330"/>
              <a:ext cx="575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0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2388093" y="4439557"/>
              <a:ext cx="575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10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388093" y="4075784"/>
              <a:ext cx="575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10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 rot="16200000">
              <a:off x="1373159" y="4431385"/>
              <a:ext cx="19246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2"/>
            <a:srcRect l="34095" t="12648" b="11257"/>
            <a:stretch/>
          </p:blipFill>
          <p:spPr>
            <a:xfrm>
              <a:off x="2703398" y="3786995"/>
              <a:ext cx="1414307" cy="1595887"/>
            </a:xfrm>
            <a:prstGeom prst="rect">
              <a:avLst/>
            </a:prstGeom>
          </p:spPr>
        </p:pic>
      </p:grpSp>
      <p:sp>
        <p:nvSpPr>
          <p:cNvPr id="2" name="文本框 1"/>
          <p:cNvSpPr txBox="1"/>
          <p:nvPr/>
        </p:nvSpPr>
        <p:spPr>
          <a:xfrm>
            <a:off x="2366624" y="3623101"/>
            <a:ext cx="1371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150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150" dirty="0">
                <a:latin typeface="Arial" panose="020B0604020202020204" pitchFamily="34" charset="0"/>
                <a:cs typeface="Arial" panose="020B0604020202020204" pitchFamily="34" charset="0"/>
              </a:rPr>
              <a:t>Cas12a-p300</a:t>
            </a:r>
            <a:endParaRPr lang="zh-CN" altLang="en-US" sz="11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4578140" y="4040953"/>
            <a:ext cx="3360428" cy="1221982"/>
            <a:chOff x="4578140" y="3964305"/>
            <a:chExt cx="3360428" cy="1221982"/>
          </a:xfrm>
        </p:grpSpPr>
        <p:sp>
          <p:nvSpPr>
            <p:cNvPr id="19" name="文本框 18"/>
            <p:cNvSpPr txBox="1"/>
            <p:nvPr/>
          </p:nvSpPr>
          <p:spPr>
            <a:xfrm>
              <a:off x="4578140" y="4227273"/>
              <a:ext cx="1229694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α-HA</a:t>
              </a:r>
            </a:p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Cas12a-p300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4742629" y="4898497"/>
              <a:ext cx="9783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/>
            <a:srcRect l="3449" t="1797" r="4153"/>
            <a:stretch/>
          </p:blipFill>
          <p:spPr>
            <a:xfrm>
              <a:off x="5771072" y="4225915"/>
              <a:ext cx="1468435" cy="418215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67227" y="4762218"/>
              <a:ext cx="1472280" cy="424069"/>
            </a:xfrm>
            <a:prstGeom prst="rect">
              <a:avLst/>
            </a:prstGeom>
          </p:spPr>
        </p:pic>
        <p:sp>
          <p:nvSpPr>
            <p:cNvPr id="28" name="文本框 27"/>
            <p:cNvSpPr txBox="1"/>
            <p:nvPr/>
          </p:nvSpPr>
          <p:spPr>
            <a:xfrm>
              <a:off x="7327811" y="4129645"/>
              <a:ext cx="6107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 214K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 flipH="1">
              <a:off x="7274372" y="4431331"/>
              <a:ext cx="720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7327811" y="4841983"/>
              <a:ext cx="6107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 55K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箭头连接符 29"/>
            <p:cNvCxnSpPr/>
            <p:nvPr/>
          </p:nvCxnSpPr>
          <p:spPr>
            <a:xfrm flipH="1">
              <a:off x="7285742" y="4961624"/>
              <a:ext cx="720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5819224" y="3964305"/>
              <a:ext cx="13682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-DOX          +DOX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图片 3">
            <a:extLst>
              <a:ext uri="{FF2B5EF4-FFF2-40B4-BE49-F238E27FC236}">
                <a16:creationId xmlns:a16="http://schemas.microsoft.com/office/drawing/2014/main" id="{030FB969-C354-ABD0-4F13-149E2BC1E2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6641" y="1458935"/>
            <a:ext cx="6081319" cy="1273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15404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B9770065-DE0B-E66A-2989-235EC245DC6A}"/>
              </a:ext>
            </a:extLst>
          </p:cNvPr>
          <p:cNvSpPr txBox="1"/>
          <p:nvPr/>
        </p:nvSpPr>
        <p:spPr>
          <a:xfrm>
            <a:off x="287594" y="514653"/>
            <a:ext cx="8568812" cy="49054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5 Comparison between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with other extended structuralized gRNAs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Gene activation guided by different extended structuralized gRNAs in the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knock-in HEK293T cell line. U6 + 27, the mature gRNAs driven by the polymerase III promoter U6 + 27 cassette; U6, the mature gRNAs driven by the polymerase III promoter U6; Pre, spacer flanked by two scaffold sequences and driven by the polymerase III promoter U6 + 27 cassette; C-L7-d27, circular gRNA with linker7 driven by the polymerase III promoter U6; C-L7, circular gRNA with linker7 driven by the polymerase III promoter U6 + 27 cassette; gRNA + 9, extending the 5’ end of the crRNA with 9 nucleotides; gRNA + 59, extending the 5’ end of the crRNA with 59 nucleotides; gRNA + T</a:t>
            </a:r>
            <a:r>
              <a:rPr lang="en-US" altLang="zh-CN" sz="14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T</a:t>
            </a:r>
            <a:r>
              <a:rPr lang="en-US" altLang="zh-CN" sz="14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extending the 3’ end of the crRNA with TTTTATTTT sequences; n=4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-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FACS analyses of the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orter cells 4 days after co-transfection with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2A-mCherry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targeting-gRNA plasmids. The cleavage efficiency was quantified by the cell ratio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‒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/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the FACS assays, n=3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-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Editing efficiency of the endogenous site VEGFA. The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knock-in HEK293T cells were transfected with different extended structuralized gRNAs, and 4 days after transfection, genome DNA was harvested and analyzed by Sanger sequencing and</a:t>
            </a:r>
            <a:r>
              <a:rPr lang="en-US" altLang="zh-CN" sz="14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racking of indels by decomposition (TIDE) assay, n=2.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1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one-way ANOVA tes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95470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文本框 33"/>
          <p:cNvSpPr txBox="1"/>
          <p:nvPr/>
        </p:nvSpPr>
        <p:spPr>
          <a:xfrm>
            <a:off x="116777" y="6246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-112392" y="6046442"/>
            <a:ext cx="93687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6 Circular gRNAs improve the gene expression or DNA cleavage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-based effectors.</a:t>
            </a:r>
          </a:p>
        </p:txBody>
      </p:sp>
      <p:sp>
        <p:nvSpPr>
          <p:cNvPr id="104" name="矩形 103"/>
          <p:cNvSpPr/>
          <p:nvPr/>
        </p:nvSpPr>
        <p:spPr>
          <a:xfrm>
            <a:off x="1627802" y="537012"/>
            <a:ext cx="1236236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Cas12a-VPR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8A8EA01F-B9E6-0BFA-85E5-58053602F0E0}"/>
              </a:ext>
            </a:extLst>
          </p:cNvPr>
          <p:cNvGrpSpPr/>
          <p:nvPr/>
        </p:nvGrpSpPr>
        <p:grpSpPr>
          <a:xfrm>
            <a:off x="4678396" y="446733"/>
            <a:ext cx="2137529" cy="2190786"/>
            <a:chOff x="3992059" y="3217828"/>
            <a:chExt cx="2137529" cy="2190786"/>
          </a:xfrm>
        </p:grpSpPr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702D915D-C553-19C4-94CB-2B1D6AD94100}"/>
                </a:ext>
              </a:extLst>
            </p:cNvPr>
            <p:cNvCxnSpPr/>
            <p:nvPr/>
          </p:nvCxnSpPr>
          <p:spPr>
            <a:xfrm flipV="1">
              <a:off x="4617216" y="3743363"/>
              <a:ext cx="8102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11FACC1C-BB92-2DC4-0A2F-D40E8EC16A1B}"/>
                </a:ext>
              </a:extLst>
            </p:cNvPr>
            <p:cNvCxnSpPr/>
            <p:nvPr/>
          </p:nvCxnSpPr>
          <p:spPr>
            <a:xfrm>
              <a:off x="4617216" y="3819117"/>
              <a:ext cx="6513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82E9C5C-C601-9691-7F3B-E87359F3C79D}"/>
                </a:ext>
              </a:extLst>
            </p:cNvPr>
            <p:cNvSpPr txBox="1"/>
            <p:nvPr/>
          </p:nvSpPr>
          <p:spPr>
            <a:xfrm>
              <a:off x="4721964" y="3682848"/>
              <a:ext cx="4562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F168F7E-2607-7C8C-3A9F-5A6666ED1453}"/>
                </a:ext>
              </a:extLst>
            </p:cNvPr>
            <p:cNvSpPr txBox="1"/>
            <p:nvPr/>
          </p:nvSpPr>
          <p:spPr>
            <a:xfrm>
              <a:off x="5532217" y="3372198"/>
              <a:ext cx="45886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12490BD4-B47C-4A25-7506-DFB8D273162B}"/>
                </a:ext>
              </a:extLst>
            </p:cNvPr>
            <p:cNvCxnSpPr/>
            <p:nvPr/>
          </p:nvCxnSpPr>
          <p:spPr>
            <a:xfrm flipV="1">
              <a:off x="4617216" y="3508561"/>
              <a:ext cx="140599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A2BF82A-A861-9266-1E39-E7BCE4A75287}"/>
                </a:ext>
              </a:extLst>
            </p:cNvPr>
            <p:cNvSpPr txBox="1"/>
            <p:nvPr/>
          </p:nvSpPr>
          <p:spPr>
            <a:xfrm>
              <a:off x="4819622" y="3604589"/>
              <a:ext cx="41142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480EFB48-7CCC-1E52-3956-0743D4EFB308}"/>
                </a:ext>
              </a:extLst>
            </p:cNvPr>
            <p:cNvCxnSpPr/>
            <p:nvPr/>
          </p:nvCxnSpPr>
          <p:spPr>
            <a:xfrm flipV="1">
              <a:off x="4617216" y="3657561"/>
              <a:ext cx="102470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C13DC1B-C4EF-B225-D8CD-EDF01288A16B}"/>
                </a:ext>
              </a:extLst>
            </p:cNvPr>
            <p:cNvSpPr txBox="1"/>
            <p:nvPr/>
          </p:nvSpPr>
          <p:spPr>
            <a:xfrm>
              <a:off x="5040970" y="3523331"/>
              <a:ext cx="43934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18086852-3474-220E-0865-9EFEBEDFF92E}"/>
                </a:ext>
              </a:extLst>
            </p:cNvPr>
            <p:cNvCxnSpPr/>
            <p:nvPr/>
          </p:nvCxnSpPr>
          <p:spPr>
            <a:xfrm flipV="1">
              <a:off x="4617216" y="3586058"/>
              <a:ext cx="12153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44244739-3308-DA5C-EF8B-72A3656EC115}"/>
                </a:ext>
              </a:extLst>
            </p:cNvPr>
            <p:cNvSpPr txBox="1"/>
            <p:nvPr/>
          </p:nvSpPr>
          <p:spPr>
            <a:xfrm>
              <a:off x="5295436" y="3447850"/>
              <a:ext cx="44117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E0AD109B-CED4-0DDB-A48F-D6165408CA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799" t="11291" r="4925" b="4772"/>
            <a:stretch/>
          </p:blipFill>
          <p:spPr>
            <a:xfrm>
              <a:off x="4191699" y="3458370"/>
              <a:ext cx="1937889" cy="1950244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857EF81-D897-C6E2-AB15-3ADE14F0DB30}"/>
                </a:ext>
              </a:extLst>
            </p:cNvPr>
            <p:cNvSpPr txBox="1"/>
            <p:nvPr/>
          </p:nvSpPr>
          <p:spPr>
            <a:xfrm rot="16200000">
              <a:off x="3335520" y="4049939"/>
              <a:ext cx="1536216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5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  <a:endParaRPr lang="zh-CN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BFF1E714-D39A-199E-502E-2031AC2F7A62}"/>
                </a:ext>
              </a:extLst>
            </p:cNvPr>
            <p:cNvSpPr txBox="1"/>
            <p:nvPr/>
          </p:nvSpPr>
          <p:spPr>
            <a:xfrm>
              <a:off x="4919467" y="3217828"/>
              <a:ext cx="76671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IL1RN</a:t>
              </a:r>
              <a:endParaRPr lang="zh-CN" alt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2ADCC9E6-BF12-2115-233C-428266032951}"/>
              </a:ext>
            </a:extLst>
          </p:cNvPr>
          <p:cNvGrpSpPr/>
          <p:nvPr/>
        </p:nvGrpSpPr>
        <p:grpSpPr>
          <a:xfrm>
            <a:off x="6905106" y="439497"/>
            <a:ext cx="2007306" cy="2167104"/>
            <a:chOff x="6256749" y="3218269"/>
            <a:chExt cx="2007306" cy="2167104"/>
          </a:xfrm>
        </p:grpSpPr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0DF3C9B-C4AD-26B2-B28B-9EDE9CC08B55}"/>
                </a:ext>
              </a:extLst>
            </p:cNvPr>
            <p:cNvSpPr txBox="1"/>
            <p:nvPr/>
          </p:nvSpPr>
          <p:spPr>
            <a:xfrm>
              <a:off x="6933634" y="3218269"/>
              <a:ext cx="76671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BG</a:t>
              </a:r>
              <a:endParaRPr lang="zh-CN" alt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92EE7AE3-A53A-CBDD-DA2D-D9148D2AAE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201" t="12442" r="2517" b="5020"/>
            <a:stretch/>
          </p:blipFill>
          <p:spPr>
            <a:xfrm>
              <a:off x="6256749" y="3473015"/>
              <a:ext cx="2007306" cy="1912358"/>
            </a:xfrm>
            <a:prstGeom prst="rect">
              <a:avLst/>
            </a:prstGeom>
          </p:spPr>
        </p:pic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CAF5A24-B6FA-F258-AD54-370E8A7FCC1E}"/>
                </a:ext>
              </a:extLst>
            </p:cNvPr>
            <p:cNvCxnSpPr/>
            <p:nvPr/>
          </p:nvCxnSpPr>
          <p:spPr>
            <a:xfrm>
              <a:off x="6628237" y="3882505"/>
              <a:ext cx="4516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9B540A99-44BC-85D4-562F-C0DB34F6B0EE}"/>
                </a:ext>
              </a:extLst>
            </p:cNvPr>
            <p:cNvCxnSpPr/>
            <p:nvPr/>
          </p:nvCxnSpPr>
          <p:spPr>
            <a:xfrm>
              <a:off x="6628237" y="3811680"/>
              <a:ext cx="82801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EA4F5BB6-BB8F-B400-5ED3-1DB986C75FFD}"/>
                </a:ext>
              </a:extLst>
            </p:cNvPr>
            <p:cNvCxnSpPr/>
            <p:nvPr/>
          </p:nvCxnSpPr>
          <p:spPr>
            <a:xfrm>
              <a:off x="6628237" y="3739533"/>
              <a:ext cx="10789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82FEFBA1-DD4E-C583-D64B-D53011D16EF0}"/>
                </a:ext>
              </a:extLst>
            </p:cNvPr>
            <p:cNvCxnSpPr/>
            <p:nvPr/>
          </p:nvCxnSpPr>
          <p:spPr>
            <a:xfrm>
              <a:off x="6628237" y="3664281"/>
              <a:ext cx="12545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8B5A3AD2-E189-ED90-49D8-15F6C02E9F29}"/>
                </a:ext>
              </a:extLst>
            </p:cNvPr>
            <p:cNvSpPr txBox="1"/>
            <p:nvPr/>
          </p:nvSpPr>
          <p:spPr>
            <a:xfrm>
              <a:off x="6693452" y="3752102"/>
              <a:ext cx="480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68819B7D-0482-0FE6-1639-BAC63DE30AB4}"/>
                </a:ext>
              </a:extLst>
            </p:cNvPr>
            <p:cNvSpPr txBox="1"/>
            <p:nvPr/>
          </p:nvSpPr>
          <p:spPr>
            <a:xfrm>
              <a:off x="6851496" y="3679259"/>
              <a:ext cx="480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B0A85DC-F143-DA81-9DB3-0E0B757B2877}"/>
                </a:ext>
              </a:extLst>
            </p:cNvPr>
            <p:cNvSpPr txBox="1"/>
            <p:nvPr/>
          </p:nvSpPr>
          <p:spPr>
            <a:xfrm>
              <a:off x="7146392" y="3606631"/>
              <a:ext cx="480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3B2898E2-CF36-F6B8-736B-E2288E5023A1}"/>
                </a:ext>
              </a:extLst>
            </p:cNvPr>
            <p:cNvSpPr txBox="1"/>
            <p:nvPr/>
          </p:nvSpPr>
          <p:spPr>
            <a:xfrm>
              <a:off x="7205426" y="3528276"/>
              <a:ext cx="480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F4BCD93B-40D8-52DC-6F59-C0525ED7EB12}"/>
                </a:ext>
              </a:extLst>
            </p:cNvPr>
            <p:cNvCxnSpPr/>
            <p:nvPr/>
          </p:nvCxnSpPr>
          <p:spPr>
            <a:xfrm>
              <a:off x="6628237" y="3583561"/>
              <a:ext cx="14302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F69EEA07-DF13-C93A-7D4E-F4E7AF823448}"/>
                </a:ext>
              </a:extLst>
            </p:cNvPr>
            <p:cNvSpPr txBox="1"/>
            <p:nvPr/>
          </p:nvSpPr>
          <p:spPr>
            <a:xfrm>
              <a:off x="7454089" y="3450310"/>
              <a:ext cx="480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43" name="文本框 42">
            <a:extLst>
              <a:ext uri="{FF2B5EF4-FFF2-40B4-BE49-F238E27FC236}">
                <a16:creationId xmlns:a16="http://schemas.microsoft.com/office/drawing/2014/main" id="{51AA1D89-92CA-62E5-E1EE-634CE18554B0}"/>
              </a:ext>
            </a:extLst>
          </p:cNvPr>
          <p:cNvSpPr txBox="1"/>
          <p:nvPr/>
        </p:nvSpPr>
        <p:spPr>
          <a:xfrm>
            <a:off x="4318388" y="6246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FBDD0E6-58FA-9114-E56A-D0EC21D50AB4}"/>
              </a:ext>
            </a:extLst>
          </p:cNvPr>
          <p:cNvSpPr txBox="1"/>
          <p:nvPr/>
        </p:nvSpPr>
        <p:spPr>
          <a:xfrm>
            <a:off x="84706" y="268790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98762765-21A4-0E5D-BA42-B93AA319AE9C}"/>
              </a:ext>
            </a:extLst>
          </p:cNvPr>
          <p:cNvSpPr/>
          <p:nvPr/>
        </p:nvSpPr>
        <p:spPr>
          <a:xfrm>
            <a:off x="1413641" y="3222982"/>
            <a:ext cx="832279" cy="2378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Cas12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F843465-9A28-378D-77F6-28476E867D9C}"/>
              </a:ext>
            </a:extLst>
          </p:cNvPr>
          <p:cNvSpPr txBox="1"/>
          <p:nvPr/>
        </p:nvSpPr>
        <p:spPr>
          <a:xfrm>
            <a:off x="3371365" y="2724752"/>
            <a:ext cx="3663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4CB21E6-9A85-EC16-6E01-21778C73902D}"/>
              </a:ext>
            </a:extLst>
          </p:cNvPr>
          <p:cNvSpPr txBox="1"/>
          <p:nvPr/>
        </p:nvSpPr>
        <p:spPr>
          <a:xfrm>
            <a:off x="6518905" y="2695034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A27A8EB7-EDFA-1B61-4FD3-3586E26BA8A7}"/>
              </a:ext>
            </a:extLst>
          </p:cNvPr>
          <p:cNvCxnSpPr/>
          <p:nvPr/>
        </p:nvCxnSpPr>
        <p:spPr>
          <a:xfrm flipH="1" flipV="1">
            <a:off x="3701215" y="2986345"/>
            <a:ext cx="0" cy="252000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3CCE5054-4DDC-34EA-BC72-4EB8B0006C43}"/>
              </a:ext>
            </a:extLst>
          </p:cNvPr>
          <p:cNvSpPr txBox="1"/>
          <p:nvPr/>
        </p:nvSpPr>
        <p:spPr>
          <a:xfrm>
            <a:off x="4263711" y="5538126"/>
            <a:ext cx="1143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25FA94A9-AB9E-2EEF-988D-9F32F5D1862E}"/>
              </a:ext>
            </a:extLst>
          </p:cNvPr>
          <p:cNvCxnSpPr/>
          <p:nvPr/>
        </p:nvCxnSpPr>
        <p:spPr>
          <a:xfrm rot="5400000" flipH="1" flipV="1">
            <a:off x="5067714" y="4216097"/>
            <a:ext cx="0" cy="270000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715D6EE2-4BE2-A743-0B94-8DEBB6155E7A}"/>
              </a:ext>
            </a:extLst>
          </p:cNvPr>
          <p:cNvSpPr txBox="1"/>
          <p:nvPr/>
        </p:nvSpPr>
        <p:spPr>
          <a:xfrm rot="16200000">
            <a:off x="3143902" y="3783067"/>
            <a:ext cx="904973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A9B335C3-444E-0C9F-F718-400947734CC8}"/>
              </a:ext>
            </a:extLst>
          </p:cNvPr>
          <p:cNvGrpSpPr/>
          <p:nvPr/>
        </p:nvGrpSpPr>
        <p:grpSpPr>
          <a:xfrm>
            <a:off x="6593173" y="3204702"/>
            <a:ext cx="2269997" cy="2230226"/>
            <a:chOff x="5346626" y="3687080"/>
            <a:chExt cx="2269997" cy="2230226"/>
          </a:xfrm>
        </p:grpSpPr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D9D3F141-1A81-66EE-0C1E-0F0F573B4B0E}"/>
                </a:ext>
              </a:extLst>
            </p:cNvPr>
            <p:cNvSpPr txBox="1"/>
            <p:nvPr/>
          </p:nvSpPr>
          <p:spPr>
            <a:xfrm rot="10800000">
              <a:off x="5346626" y="3756761"/>
              <a:ext cx="523220" cy="192434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NeonGreen</a:t>
              </a:r>
              <a:r>
                <a:rPr lang="en-US" altLang="zh-CN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Cherry</a:t>
              </a:r>
              <a:r>
                <a:rPr lang="en-US" altLang="zh-CN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</a:p>
            <a:p>
              <a:pPr algn="ctr"/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Cherry</a:t>
              </a:r>
              <a:r>
                <a:rPr lang="en-US" altLang="zh-CN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C108FCDE-2FDF-93FD-98B3-A0FCE423F9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2650" r="30836" b="19644"/>
            <a:stretch/>
          </p:blipFill>
          <p:spPr>
            <a:xfrm>
              <a:off x="5473111" y="3687080"/>
              <a:ext cx="2143512" cy="1908000"/>
            </a:xfrm>
            <a:prstGeom prst="rect">
              <a:avLst/>
            </a:prstGeom>
          </p:spPr>
        </p:pic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33698385-275A-B4B8-3273-375A36357237}"/>
                </a:ext>
              </a:extLst>
            </p:cNvPr>
            <p:cNvGrpSpPr/>
            <p:nvPr/>
          </p:nvGrpSpPr>
          <p:grpSpPr>
            <a:xfrm>
              <a:off x="5663773" y="3881868"/>
              <a:ext cx="1769719" cy="2035438"/>
              <a:chOff x="998048" y="4108121"/>
              <a:chExt cx="1769719" cy="2035438"/>
            </a:xfrm>
          </p:grpSpPr>
          <p:cxnSp>
            <p:nvCxnSpPr>
              <p:cNvPr id="49" name="直接连接符 48">
                <a:extLst>
                  <a:ext uri="{FF2B5EF4-FFF2-40B4-BE49-F238E27FC236}">
                    <a16:creationId xmlns:a16="http://schemas.microsoft.com/office/drawing/2014/main" id="{B674599F-DBF4-3805-4798-A4F5083660D0}"/>
                  </a:ext>
                </a:extLst>
              </p:cNvPr>
              <p:cNvCxnSpPr/>
              <p:nvPr/>
            </p:nvCxnSpPr>
            <p:spPr>
              <a:xfrm>
                <a:off x="1865980" y="4303976"/>
                <a:ext cx="828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521A33D1-1D48-76C2-3807-8FFAF3A09B19}"/>
                  </a:ext>
                </a:extLst>
              </p:cNvPr>
              <p:cNvSpPr txBox="1"/>
              <p:nvPr/>
            </p:nvSpPr>
            <p:spPr>
              <a:xfrm>
                <a:off x="2109929" y="4108121"/>
                <a:ext cx="23756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CN" altLang="en-US" sz="105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*</a:t>
                </a:r>
                <a:endPara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B33C9F5A-D921-A782-A081-AE69870E8601}"/>
                  </a:ext>
                </a:extLst>
              </p:cNvPr>
              <p:cNvSpPr txBox="1"/>
              <p:nvPr/>
            </p:nvSpPr>
            <p:spPr>
              <a:xfrm rot="19165341">
                <a:off x="998048" y="5881949"/>
                <a:ext cx="80411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 gRNA</a:t>
                </a:r>
                <a:endPara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3A4AE040-1C5A-79BD-6A97-7072F8FF7514}"/>
                  </a:ext>
                </a:extLst>
              </p:cNvPr>
              <p:cNvSpPr txBox="1"/>
              <p:nvPr/>
            </p:nvSpPr>
            <p:spPr>
              <a:xfrm rot="19165341">
                <a:off x="1319916" y="5882875"/>
                <a:ext cx="8041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6+27</a:t>
                </a:r>
                <a:endPara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48FD720E-144E-1CC3-261B-3BB8960246A0}"/>
                  </a:ext>
                </a:extLst>
              </p:cNvPr>
              <p:cNvSpPr txBox="1"/>
              <p:nvPr/>
            </p:nvSpPr>
            <p:spPr>
              <a:xfrm rot="19165341">
                <a:off x="1641784" y="5882875"/>
                <a:ext cx="8041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  <a:endPara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4780B8D4-BF22-53FF-922C-C4F14756729E}"/>
                  </a:ext>
                </a:extLst>
              </p:cNvPr>
              <p:cNvSpPr txBox="1"/>
              <p:nvPr/>
            </p:nvSpPr>
            <p:spPr>
              <a:xfrm rot="19165341">
                <a:off x="1963653" y="5882875"/>
                <a:ext cx="8041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L1</a:t>
                </a:r>
                <a:endPara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6" name="矩形 55">
            <a:extLst>
              <a:ext uri="{FF2B5EF4-FFF2-40B4-BE49-F238E27FC236}">
                <a16:creationId xmlns:a16="http://schemas.microsoft.com/office/drawing/2014/main" id="{0BA882DB-4815-F2A4-12F2-A7328DF1D918}"/>
              </a:ext>
            </a:extLst>
          </p:cNvPr>
          <p:cNvSpPr/>
          <p:nvPr/>
        </p:nvSpPr>
        <p:spPr>
          <a:xfrm>
            <a:off x="6154585" y="156459"/>
            <a:ext cx="1236236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Cas12a-VPR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024D59D5-1C4D-A8B3-1973-B841B8BDCF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210761" y="749504"/>
            <a:ext cx="5349501" cy="973454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12CDB848-F2B8-BA87-A867-E444155931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59680" y="3443098"/>
            <a:ext cx="3985704" cy="93364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E416C46A-0025-7EEC-06A6-ECC97A15847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12919" y="2924636"/>
            <a:ext cx="2808000" cy="24978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45940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7F698B6-F960-B501-01F7-17A4191D9901}"/>
              </a:ext>
            </a:extLst>
          </p:cNvPr>
          <p:cNvSpPr txBox="1"/>
          <p:nvPr/>
        </p:nvSpPr>
        <p:spPr>
          <a:xfrm>
            <a:off x="610583" y="697569"/>
            <a:ext cx="8085066" cy="32896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6 Circular gRNAs improve the gene expression or DNA cleavage of 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based effectors. a-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Gene activation guided by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with different linkers in HEK293T cells co-transfected with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VPR and indicated gRNAs. Western blot of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VPR proteins in transfected HEK293T cells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 Quantitative RT-PCR revealed relative mRNA expression of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L1R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HBG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-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FACS analyses of the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orter cells 4 days after co-transfection with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2A-mCherry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targeting-gRNA plasmids. Western blot of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proteins in transfecte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orter cells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 FACS analyses showed the cleavage of target gene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mediated by different gRNAs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he cleavage efficiency was quantified by the cell ratio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‒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/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the FACS assays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 For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, 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n = 4 independent experiments.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1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one-way ANOVA tes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48770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46654" y="26525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19550" y="32874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95749" y="3591961"/>
            <a:ext cx="779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VDER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组合 66"/>
          <p:cNvGrpSpPr/>
          <p:nvPr/>
        </p:nvGrpSpPr>
        <p:grpSpPr>
          <a:xfrm>
            <a:off x="533517" y="4091088"/>
            <a:ext cx="2960701" cy="1956640"/>
            <a:chOff x="5118022" y="919998"/>
            <a:chExt cx="2960701" cy="1956640"/>
          </a:xfrm>
        </p:grpSpPr>
        <p:pic>
          <p:nvPicPr>
            <p:cNvPr id="51" name="图片 50"/>
            <p:cNvPicPr>
              <a:picLocks noChangeAspect="1"/>
            </p:cNvPicPr>
            <p:nvPr/>
          </p:nvPicPr>
          <p:blipFill rotWithShape="1">
            <a:blip r:embed="rId2"/>
            <a:srcRect l="7793" r="2177" b="11733"/>
            <a:stretch/>
          </p:blipFill>
          <p:spPr>
            <a:xfrm>
              <a:off x="5361080" y="919998"/>
              <a:ext cx="2717643" cy="1956640"/>
            </a:xfrm>
            <a:prstGeom prst="rect">
              <a:avLst/>
            </a:prstGeom>
          </p:spPr>
        </p:pic>
        <p:sp>
          <p:nvSpPr>
            <p:cNvPr id="52" name="文本框 51"/>
            <p:cNvSpPr txBox="1"/>
            <p:nvPr/>
          </p:nvSpPr>
          <p:spPr>
            <a:xfrm rot="16200000">
              <a:off x="4875610" y="1568507"/>
              <a:ext cx="715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el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直接连接符 58"/>
            <p:cNvCxnSpPr/>
            <p:nvPr/>
          </p:nvCxnSpPr>
          <p:spPr>
            <a:xfrm>
              <a:off x="5971443" y="1726216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文本框 59"/>
            <p:cNvSpPr txBox="1"/>
            <p:nvPr/>
          </p:nvSpPr>
          <p:spPr>
            <a:xfrm>
              <a:off x="5912802" y="1564067"/>
              <a:ext cx="3362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6337037" y="1681805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文本框 61"/>
            <p:cNvSpPr txBox="1"/>
            <p:nvPr/>
          </p:nvSpPr>
          <p:spPr>
            <a:xfrm>
              <a:off x="6278396" y="1519656"/>
              <a:ext cx="3362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63" name="直接连接符 62"/>
            <p:cNvCxnSpPr/>
            <p:nvPr/>
          </p:nvCxnSpPr>
          <p:spPr>
            <a:xfrm>
              <a:off x="6681277" y="2003525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文本框 63"/>
            <p:cNvSpPr txBox="1"/>
            <p:nvPr/>
          </p:nvSpPr>
          <p:spPr>
            <a:xfrm>
              <a:off x="6622636" y="1841376"/>
              <a:ext cx="3362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65" name="直接连接符 64"/>
            <p:cNvCxnSpPr/>
            <p:nvPr/>
          </p:nvCxnSpPr>
          <p:spPr>
            <a:xfrm>
              <a:off x="6984078" y="1630592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文本框 65"/>
            <p:cNvSpPr txBox="1"/>
            <p:nvPr/>
          </p:nvSpPr>
          <p:spPr>
            <a:xfrm>
              <a:off x="6925437" y="1468443"/>
              <a:ext cx="3362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69" name="文本框 68"/>
          <p:cNvSpPr txBox="1"/>
          <p:nvPr/>
        </p:nvSpPr>
        <p:spPr>
          <a:xfrm>
            <a:off x="3050574" y="283024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3592821" y="32874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5201146" y="32874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6798415" y="32874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7" name="组合 76"/>
          <p:cNvGrpSpPr/>
          <p:nvPr/>
        </p:nvGrpSpPr>
        <p:grpSpPr>
          <a:xfrm>
            <a:off x="5246281" y="3626830"/>
            <a:ext cx="1430046" cy="2245519"/>
            <a:chOff x="4074660" y="3928146"/>
            <a:chExt cx="1430046" cy="2171106"/>
          </a:xfrm>
        </p:grpSpPr>
        <p:pic>
          <p:nvPicPr>
            <p:cNvPr id="73" name="图片 7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76131" y="4080878"/>
              <a:ext cx="1228575" cy="2018374"/>
            </a:xfrm>
            <a:prstGeom prst="rect">
              <a:avLst/>
            </a:prstGeom>
          </p:spPr>
        </p:pic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61E73666-D751-45F9-9A67-03FA3E245A15}"/>
                </a:ext>
              </a:extLst>
            </p:cNvPr>
            <p:cNvSpPr txBox="1"/>
            <p:nvPr/>
          </p:nvSpPr>
          <p:spPr>
            <a:xfrm rot="10800000">
              <a:off x="4074660" y="4094488"/>
              <a:ext cx="323165" cy="156553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pecificity Index</a:t>
              </a: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61E73666-D751-45F9-9A67-03FA3E245A15}"/>
                </a:ext>
              </a:extLst>
            </p:cNvPr>
            <p:cNvSpPr txBox="1"/>
            <p:nvPr/>
          </p:nvSpPr>
          <p:spPr>
            <a:xfrm rot="10800000">
              <a:off x="4651555" y="3928146"/>
              <a:ext cx="307777" cy="6704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9996</a:t>
              </a: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61E73666-D751-45F9-9A67-03FA3E245A15}"/>
                </a:ext>
              </a:extLst>
            </p:cNvPr>
            <p:cNvSpPr txBox="1"/>
            <p:nvPr/>
          </p:nvSpPr>
          <p:spPr>
            <a:xfrm rot="10800000">
              <a:off x="5037914" y="3928146"/>
              <a:ext cx="307777" cy="6704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9968</a:t>
              </a:r>
            </a:p>
          </p:txBody>
        </p:sp>
      </p:grpSp>
      <p:grpSp>
        <p:nvGrpSpPr>
          <p:cNvPr id="95" name="组合 94"/>
          <p:cNvGrpSpPr/>
          <p:nvPr/>
        </p:nvGrpSpPr>
        <p:grpSpPr>
          <a:xfrm>
            <a:off x="6885273" y="3835246"/>
            <a:ext cx="1370036" cy="2020240"/>
            <a:chOff x="7284676" y="4154095"/>
            <a:chExt cx="1370036" cy="1870322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8DD55BFB-7DCE-443A-BD3D-4140D05C768D}"/>
                </a:ext>
              </a:extLst>
            </p:cNvPr>
            <p:cNvSpPr txBox="1"/>
            <p:nvPr/>
          </p:nvSpPr>
          <p:spPr>
            <a:xfrm rot="10800000">
              <a:off x="7284676" y="4241677"/>
              <a:ext cx="323165" cy="105753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 off-Targets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1" name="图片 9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466712" y="4154095"/>
              <a:ext cx="1188000" cy="1870322"/>
            </a:xfrm>
            <a:prstGeom prst="rect">
              <a:avLst/>
            </a:prstGeom>
          </p:spPr>
        </p:pic>
      </p:grpSp>
      <p:pic>
        <p:nvPicPr>
          <p:cNvPr id="92" name="图片 9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8948" y="644240"/>
            <a:ext cx="3243913" cy="2359665"/>
          </a:xfrm>
          <a:prstGeom prst="rect">
            <a:avLst/>
          </a:prstGeom>
        </p:spPr>
      </p:pic>
      <p:grpSp>
        <p:nvGrpSpPr>
          <p:cNvPr id="94" name="组合 93"/>
          <p:cNvGrpSpPr/>
          <p:nvPr/>
        </p:nvGrpSpPr>
        <p:grpSpPr>
          <a:xfrm>
            <a:off x="3741080" y="3625106"/>
            <a:ext cx="1404000" cy="2282770"/>
            <a:chOff x="3885370" y="4057769"/>
            <a:chExt cx="1418427" cy="2102570"/>
          </a:xfrm>
        </p:grpSpPr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AB9C0B69-84DA-4747-9D9A-765C6B071106}"/>
                </a:ext>
              </a:extLst>
            </p:cNvPr>
            <p:cNvSpPr txBox="1"/>
            <p:nvPr/>
          </p:nvSpPr>
          <p:spPr>
            <a:xfrm rot="16200000">
              <a:off x="3196898" y="4746241"/>
              <a:ext cx="174627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On-target efficiency</a:t>
              </a:r>
            </a:p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normalized to Pre-CVDER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4651078" y="4070396"/>
              <a:ext cx="470428" cy="212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.67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3" name="图片 9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21150" y="4093372"/>
              <a:ext cx="1082647" cy="2066967"/>
            </a:xfrm>
            <a:prstGeom prst="rect">
              <a:avLst/>
            </a:prstGeom>
          </p:spPr>
        </p:pic>
      </p:grpSp>
      <p:sp>
        <p:nvSpPr>
          <p:cNvPr id="96" name="矩形 95"/>
          <p:cNvSpPr/>
          <p:nvPr/>
        </p:nvSpPr>
        <p:spPr>
          <a:xfrm>
            <a:off x="-13886" y="6146079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7 Multiplexed gene activation and cleavage guided by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RNA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8" name="组合 7"/>
          <p:cNvGrpSpPr/>
          <p:nvPr/>
        </p:nvGrpSpPr>
        <p:grpSpPr>
          <a:xfrm>
            <a:off x="394173" y="1187301"/>
            <a:ext cx="2520000" cy="1553592"/>
            <a:chOff x="670347" y="1077895"/>
            <a:chExt cx="2520000" cy="1553592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7"/>
            <a:srcRect l="9522" t="4058" r="2350" b="14878"/>
            <a:stretch/>
          </p:blipFill>
          <p:spPr>
            <a:xfrm>
              <a:off x="670347" y="1077895"/>
              <a:ext cx="2520000" cy="1553592"/>
            </a:xfrm>
            <a:prstGeom prst="rect">
              <a:avLst/>
            </a:prstGeom>
          </p:spPr>
        </p:pic>
        <p:sp>
          <p:nvSpPr>
            <p:cNvPr id="53" name="文本框 52"/>
            <p:cNvSpPr txBox="1"/>
            <p:nvPr/>
          </p:nvSpPr>
          <p:spPr>
            <a:xfrm>
              <a:off x="2063478" y="1300928"/>
              <a:ext cx="4707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54" name="直接连接符 53"/>
            <p:cNvCxnSpPr/>
            <p:nvPr/>
          </p:nvCxnSpPr>
          <p:spPr>
            <a:xfrm flipV="1">
              <a:off x="2190841" y="1440524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/>
          </p:nvSpPr>
          <p:spPr>
            <a:xfrm>
              <a:off x="991022" y="1840149"/>
              <a:ext cx="4707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56" name="直接连接符 55"/>
            <p:cNvCxnSpPr/>
            <p:nvPr/>
          </p:nvCxnSpPr>
          <p:spPr>
            <a:xfrm flipV="1">
              <a:off x="1118385" y="1979745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/>
            <p:cNvSpPr txBox="1"/>
            <p:nvPr/>
          </p:nvSpPr>
          <p:spPr>
            <a:xfrm>
              <a:off x="1534111" y="1250030"/>
              <a:ext cx="4707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68" name="直接连接符 67"/>
            <p:cNvCxnSpPr/>
            <p:nvPr/>
          </p:nvCxnSpPr>
          <p:spPr>
            <a:xfrm flipV="1">
              <a:off x="1661474" y="1389626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文本框 101"/>
          <p:cNvSpPr txBox="1"/>
          <p:nvPr/>
        </p:nvSpPr>
        <p:spPr>
          <a:xfrm>
            <a:off x="401491" y="677180"/>
            <a:ext cx="506059" cy="253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I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2189004" y="750163"/>
            <a:ext cx="504682" cy="2231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50" b="1" i="1" dirty="0">
                <a:latin typeface="Arial" panose="020B0604020202020204" pitchFamily="34" charset="0"/>
                <a:cs typeface="Arial" panose="020B0604020202020204" pitchFamily="34" charset="0"/>
              </a:rPr>
              <a:t>HBG</a:t>
            </a:r>
            <a:endParaRPr lang="zh-CN" altLang="en-US" sz="8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1589406" y="750163"/>
            <a:ext cx="637143" cy="2231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50" b="1" i="1" dirty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r>
              <a:rPr lang="en-US" altLang="zh-CN" sz="8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1090106" y="750163"/>
            <a:ext cx="504682" cy="2231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50" b="1" i="1" dirty="0">
                <a:latin typeface="Arial" panose="020B0604020202020204" pitchFamily="34" charset="0"/>
                <a:cs typeface="Arial" panose="020B0604020202020204" pitchFamily="34" charset="0"/>
              </a:rPr>
              <a:t>NTT</a:t>
            </a:r>
            <a:endParaRPr lang="zh-CN" altLang="en-US" sz="8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8366" y="564422"/>
            <a:ext cx="1644281" cy="612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74C8A64-770A-CA37-99CB-BAF4772C9D5A}"/>
              </a:ext>
            </a:extLst>
          </p:cNvPr>
          <p:cNvSpPr txBox="1"/>
          <p:nvPr/>
        </p:nvSpPr>
        <p:spPr>
          <a:xfrm>
            <a:off x="6606601" y="26525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C99EF1B-FB2A-DB5D-BBE2-EBD4DDFCC3A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3009" y="3375294"/>
            <a:ext cx="2871714" cy="756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6EE13E78-B56E-6C86-7472-D9F24718C16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6277" b="66918"/>
          <a:stretch/>
        </p:blipFill>
        <p:spPr>
          <a:xfrm>
            <a:off x="7732805" y="366618"/>
            <a:ext cx="824542" cy="468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0C857B85-12C5-B6B4-8151-F8D24E8BD6B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39367"/>
          <a:stretch/>
        </p:blipFill>
        <p:spPr>
          <a:xfrm>
            <a:off x="6752605" y="1720151"/>
            <a:ext cx="1527287" cy="144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0496FD3C-E643-3AE9-A651-E387174D8A1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39367"/>
          <a:stretch/>
        </p:blipFill>
        <p:spPr>
          <a:xfrm>
            <a:off x="6765370" y="382945"/>
            <a:ext cx="1440264" cy="1440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284F9BE9-34F0-3C9C-02E4-C89A75A13863}"/>
              </a:ext>
            </a:extLst>
          </p:cNvPr>
          <p:cNvSpPr txBox="1"/>
          <p:nvPr/>
        </p:nvSpPr>
        <p:spPr>
          <a:xfrm rot="16200000">
            <a:off x="-606367" y="1692890"/>
            <a:ext cx="17936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24201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CB8D2DDE-3577-28DA-6AD5-5E7EA4233B40}"/>
              </a:ext>
            </a:extLst>
          </p:cNvPr>
          <p:cNvSpPr txBox="1"/>
          <p:nvPr/>
        </p:nvSpPr>
        <p:spPr>
          <a:xfrm>
            <a:off x="622381" y="1895244"/>
            <a:ext cx="8250249" cy="1350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7 Multiplexed gene activation and cleavage guided by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s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Multiplexed gene activation guided by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the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KI HEK293T cells, n=4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Deep-seq shows multiplexed gene cleavage guided by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HEK293T cells, n=3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-g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ag-seq shows multiplexed gene cleavage guided by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the KI HEK293T cells. 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1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Student’s t-tes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10126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矩形 78"/>
          <p:cNvSpPr/>
          <p:nvPr/>
        </p:nvSpPr>
        <p:spPr>
          <a:xfrm>
            <a:off x="52005" y="5551939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8 Efficient and specific RNA cleavage activity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RNA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D894B60-813E-4B12-B709-81715E4A2A49}"/>
              </a:ext>
            </a:extLst>
          </p:cNvPr>
          <p:cNvSpPr txBox="1"/>
          <p:nvPr/>
        </p:nvSpPr>
        <p:spPr>
          <a:xfrm>
            <a:off x="474895" y="55818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0E22408-7D56-D7C4-F7A6-B0CEDA3CD1E5}"/>
              </a:ext>
            </a:extLst>
          </p:cNvPr>
          <p:cNvSpPr txBox="1"/>
          <p:nvPr/>
        </p:nvSpPr>
        <p:spPr>
          <a:xfrm>
            <a:off x="4718222" y="41968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DBF21F3E-BD8D-8C9C-8B19-A8067A8995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669" y="1030362"/>
            <a:ext cx="4805169" cy="1155561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A32D868-89E5-3B18-DEC9-D227893AD2DD}"/>
              </a:ext>
            </a:extLst>
          </p:cNvPr>
          <p:cNvSpPr txBox="1"/>
          <p:nvPr/>
        </p:nvSpPr>
        <p:spPr>
          <a:xfrm>
            <a:off x="548338" y="28874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9D4EBBF-51A2-6754-B0B0-AF650D2E56F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62" r="19616"/>
          <a:stretch/>
        </p:blipFill>
        <p:spPr>
          <a:xfrm>
            <a:off x="6827567" y="545829"/>
            <a:ext cx="1248721" cy="218345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972B561E-5769-05CD-9C06-FF322DF4A6CE}"/>
              </a:ext>
            </a:extLst>
          </p:cNvPr>
          <p:cNvSpPr txBox="1"/>
          <p:nvPr/>
        </p:nvSpPr>
        <p:spPr>
          <a:xfrm rot="16200000">
            <a:off x="4186133" y="1478056"/>
            <a:ext cx="1802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B1E45C4-EE7F-46FF-B44E-4184704D1EDE}"/>
              </a:ext>
            </a:extLst>
          </p:cNvPr>
          <p:cNvSpPr txBox="1"/>
          <p:nvPr/>
        </p:nvSpPr>
        <p:spPr>
          <a:xfrm rot="16200000">
            <a:off x="5817797" y="1465696"/>
            <a:ext cx="1802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1B5440B0-FA6E-5728-7404-6511D11B5EC1}"/>
              </a:ext>
            </a:extLst>
          </p:cNvPr>
          <p:cNvCxnSpPr>
            <a:cxnSpLocks/>
          </p:cNvCxnSpPr>
          <p:nvPr/>
        </p:nvCxnSpPr>
        <p:spPr>
          <a:xfrm>
            <a:off x="7560139" y="1497662"/>
            <a:ext cx="3512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1AADDD3-1456-A4A5-85DC-9CA53D5289C8}"/>
              </a:ext>
            </a:extLst>
          </p:cNvPr>
          <p:cNvSpPr txBox="1"/>
          <p:nvPr/>
        </p:nvSpPr>
        <p:spPr>
          <a:xfrm>
            <a:off x="7544934" y="1329164"/>
            <a:ext cx="37823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  <a:p>
            <a:pPr algn="ctr"/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813D712D-470F-F518-7346-6F72F2F8FC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13597" y="587445"/>
            <a:ext cx="1248720" cy="2026168"/>
          </a:xfrm>
          <a:prstGeom prst="rect">
            <a:avLst/>
          </a:prstGeom>
        </p:spPr>
      </p:pic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D6D0798-F392-CF68-703F-46118917C030}"/>
              </a:ext>
            </a:extLst>
          </p:cNvPr>
          <p:cNvCxnSpPr>
            <a:cxnSpLocks/>
          </p:cNvCxnSpPr>
          <p:nvPr/>
        </p:nvCxnSpPr>
        <p:spPr>
          <a:xfrm>
            <a:off x="5953769" y="1807563"/>
            <a:ext cx="3512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52B841B4-3D78-AE7D-0F90-A9BC38FFCB4B}"/>
              </a:ext>
            </a:extLst>
          </p:cNvPr>
          <p:cNvSpPr txBox="1"/>
          <p:nvPr/>
        </p:nvSpPr>
        <p:spPr>
          <a:xfrm>
            <a:off x="5938564" y="1676265"/>
            <a:ext cx="3782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9ADE081-B9AF-B90D-8095-A31C3BF821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1378" y="3042611"/>
            <a:ext cx="7561244" cy="22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06010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598A773-6E57-FFB5-3D46-9334ACD93827}"/>
              </a:ext>
            </a:extLst>
          </p:cNvPr>
          <p:cNvSpPr txBox="1"/>
          <p:nvPr/>
        </p:nvSpPr>
        <p:spPr>
          <a:xfrm>
            <a:off x="576662" y="1405598"/>
            <a:ext cx="8325464" cy="1350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8 Efficient and specific RNA cleavage of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Western blot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proteins in the transfecte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orter cells. b, The RNA cleavage efficienc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on endogenous genes in MCF Cell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he specific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directed gene repression showed with volcano plot.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q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Fold change &gt;2.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Student’s t-tes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68507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文本框 30">
            <a:extLst>
              <a:ext uri="{FF2B5EF4-FFF2-40B4-BE49-F238E27FC236}">
                <a16:creationId xmlns:a16="http://schemas.microsoft.com/office/drawing/2014/main" id="{744F3B89-494B-D55B-02CD-59A4CCC72F6F}"/>
              </a:ext>
            </a:extLst>
          </p:cNvPr>
          <p:cNvSpPr txBox="1"/>
          <p:nvPr/>
        </p:nvSpPr>
        <p:spPr>
          <a:xfrm rot="16200000">
            <a:off x="5535964" y="673716"/>
            <a:ext cx="7322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A19C172-8750-E3C5-A39B-A1608F1933DF}"/>
              </a:ext>
            </a:extLst>
          </p:cNvPr>
          <p:cNvSpPr txBox="1"/>
          <p:nvPr/>
        </p:nvSpPr>
        <p:spPr>
          <a:xfrm rot="16200000">
            <a:off x="5514134" y="1410710"/>
            <a:ext cx="7484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7DA9EB3-62B0-5AFE-A738-DD417472B1F6}"/>
              </a:ext>
            </a:extLst>
          </p:cNvPr>
          <p:cNvSpPr txBox="1"/>
          <p:nvPr/>
        </p:nvSpPr>
        <p:spPr>
          <a:xfrm rot="16200000">
            <a:off x="5530438" y="2049174"/>
            <a:ext cx="7484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C4AC37A-61E6-7602-3A76-BE567641EA8C}"/>
              </a:ext>
            </a:extLst>
          </p:cNvPr>
          <p:cNvSpPr txBox="1"/>
          <p:nvPr/>
        </p:nvSpPr>
        <p:spPr>
          <a:xfrm rot="16200000">
            <a:off x="5565083" y="2630501"/>
            <a:ext cx="690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99C2CDC-D126-7B05-32F9-4D316E344B27}"/>
              </a:ext>
            </a:extLst>
          </p:cNvPr>
          <p:cNvSpPr txBox="1"/>
          <p:nvPr/>
        </p:nvSpPr>
        <p:spPr>
          <a:xfrm>
            <a:off x="2982860" y="309639"/>
            <a:ext cx="814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ight-fiel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E746A50-84C5-7EE1-EF3D-89A39BBF4AA2}"/>
              </a:ext>
            </a:extLst>
          </p:cNvPr>
          <p:cNvSpPr txBox="1"/>
          <p:nvPr/>
        </p:nvSpPr>
        <p:spPr>
          <a:xfrm>
            <a:off x="3797447" y="303540"/>
            <a:ext cx="10843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033FFD7-8CD6-3018-071C-F5CA487F52DC}"/>
              </a:ext>
            </a:extLst>
          </p:cNvPr>
          <p:cNvSpPr txBox="1"/>
          <p:nvPr/>
        </p:nvSpPr>
        <p:spPr>
          <a:xfrm>
            <a:off x="4786964" y="303115"/>
            <a:ext cx="814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6F74A8E-C335-0465-8AF3-3C6BB4B4D7D7}"/>
              </a:ext>
            </a:extLst>
          </p:cNvPr>
          <p:cNvSpPr txBox="1"/>
          <p:nvPr/>
        </p:nvSpPr>
        <p:spPr>
          <a:xfrm rot="16200000">
            <a:off x="2319465" y="725138"/>
            <a:ext cx="800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T g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4C1D9ED-E2D7-6A80-644C-314FF5BE08D8}"/>
              </a:ext>
            </a:extLst>
          </p:cNvPr>
          <p:cNvSpPr txBox="1"/>
          <p:nvPr/>
        </p:nvSpPr>
        <p:spPr>
          <a:xfrm rot="16200000">
            <a:off x="2319464" y="1294279"/>
            <a:ext cx="800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40C396B8-E3FC-45C4-69D8-00E9D210B32E}"/>
              </a:ext>
            </a:extLst>
          </p:cNvPr>
          <p:cNvSpPr txBox="1"/>
          <p:nvPr/>
        </p:nvSpPr>
        <p:spPr>
          <a:xfrm rot="16200000">
            <a:off x="2321272" y="1971832"/>
            <a:ext cx="800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98A16EE-AEB3-39C6-DB52-EBA2CFA6B74A}"/>
              </a:ext>
            </a:extLst>
          </p:cNvPr>
          <p:cNvSpPr txBox="1"/>
          <p:nvPr/>
        </p:nvSpPr>
        <p:spPr>
          <a:xfrm rot="16200000">
            <a:off x="2311812" y="2624938"/>
            <a:ext cx="800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Sp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A69EEA3-FA95-69C4-0E4D-5B06EE9A772C}"/>
              </a:ext>
            </a:extLst>
          </p:cNvPr>
          <p:cNvSpPr txBox="1"/>
          <p:nvPr/>
        </p:nvSpPr>
        <p:spPr>
          <a:xfrm>
            <a:off x="1487410" y="5740466"/>
            <a:ext cx="1304898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50" b="1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7D12226-577C-2105-D885-DD0921306C72}"/>
              </a:ext>
            </a:extLst>
          </p:cNvPr>
          <p:cNvSpPr txBox="1"/>
          <p:nvPr/>
        </p:nvSpPr>
        <p:spPr>
          <a:xfrm rot="16200000">
            <a:off x="264451" y="4434675"/>
            <a:ext cx="904973" cy="3770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50" b="1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B8A61B1F-4BC8-31E6-A05A-72A916C166AF}"/>
              </a:ext>
            </a:extLst>
          </p:cNvPr>
          <p:cNvCxnSpPr>
            <a:cxnSpLocks/>
          </p:cNvCxnSpPr>
          <p:nvPr/>
        </p:nvCxnSpPr>
        <p:spPr>
          <a:xfrm>
            <a:off x="861050" y="5785422"/>
            <a:ext cx="1931258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7A046A7E-2358-4E6A-2A49-42F170130E5F}"/>
              </a:ext>
            </a:extLst>
          </p:cNvPr>
          <p:cNvCxnSpPr>
            <a:cxnSpLocks/>
          </p:cNvCxnSpPr>
          <p:nvPr/>
        </p:nvCxnSpPr>
        <p:spPr>
          <a:xfrm flipV="1">
            <a:off x="752068" y="3993721"/>
            <a:ext cx="0" cy="161251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B06EF4D3-EE86-9C83-5536-143E7C8274FA}"/>
              </a:ext>
            </a:extLst>
          </p:cNvPr>
          <p:cNvSpPr txBox="1"/>
          <p:nvPr/>
        </p:nvSpPr>
        <p:spPr>
          <a:xfrm>
            <a:off x="316911" y="12883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D428C56-C914-1DC1-1D4F-5FDCA257DA2D}"/>
              </a:ext>
            </a:extLst>
          </p:cNvPr>
          <p:cNvSpPr txBox="1"/>
          <p:nvPr/>
        </p:nvSpPr>
        <p:spPr>
          <a:xfrm>
            <a:off x="2320133" y="15119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C25C95D-266B-286F-F879-44C7BB59C99D}"/>
              </a:ext>
            </a:extLst>
          </p:cNvPr>
          <p:cNvSpPr txBox="1"/>
          <p:nvPr/>
        </p:nvSpPr>
        <p:spPr>
          <a:xfrm>
            <a:off x="343180" y="3261204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E9D16435-CB34-BDF4-675C-E0D48961BE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59219" y="3902914"/>
            <a:ext cx="1709441" cy="1944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67308D78-64B4-7165-9933-F669C00016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53036" y="3901149"/>
            <a:ext cx="1747784" cy="19440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6114747-82DC-1AEE-5562-A53811B8003C}"/>
              </a:ext>
            </a:extLst>
          </p:cNvPr>
          <p:cNvSpPr txBox="1"/>
          <p:nvPr/>
        </p:nvSpPr>
        <p:spPr>
          <a:xfrm>
            <a:off x="6125249" y="278719"/>
            <a:ext cx="814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ight-fiel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4891D52-F582-9432-6FCE-2271D536B283}"/>
              </a:ext>
            </a:extLst>
          </p:cNvPr>
          <p:cNvSpPr txBox="1"/>
          <p:nvPr/>
        </p:nvSpPr>
        <p:spPr>
          <a:xfrm>
            <a:off x="6939836" y="279676"/>
            <a:ext cx="10843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C160D11-AFD0-BA65-3523-EEB7EE5BD820}"/>
              </a:ext>
            </a:extLst>
          </p:cNvPr>
          <p:cNvSpPr txBox="1"/>
          <p:nvPr/>
        </p:nvSpPr>
        <p:spPr>
          <a:xfrm>
            <a:off x="7920812" y="276859"/>
            <a:ext cx="814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DBAB531F-864A-D24A-F8AA-4DC9408A416D}"/>
              </a:ext>
            </a:extLst>
          </p:cNvPr>
          <p:cNvSpPr/>
          <p:nvPr/>
        </p:nvSpPr>
        <p:spPr>
          <a:xfrm>
            <a:off x="266969" y="6425189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9 The trans-cleavage activity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–mediated exogenous transcripts degradation.</a:t>
            </a:r>
          </a:p>
        </p:txBody>
      </p:sp>
      <p:sp>
        <p:nvSpPr>
          <p:cNvPr id="5" name="文本框 50">
            <a:extLst>
              <a:ext uri="{FF2B5EF4-FFF2-40B4-BE49-F238E27FC236}">
                <a16:creationId xmlns:a16="http://schemas.microsoft.com/office/drawing/2014/main" id="{4E65E4D0-560A-3ED5-F040-739773A1AD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901" y="432811"/>
            <a:ext cx="128251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RNAs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D9F1ECDA-D21A-CABA-6050-7DE35E84BBED}"/>
              </a:ext>
            </a:extLst>
          </p:cNvPr>
          <p:cNvSpPr/>
          <p:nvPr/>
        </p:nvSpPr>
        <p:spPr>
          <a:xfrm>
            <a:off x="929035" y="730304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8E02A1D-6A3B-8787-F0AD-51A58ECA0157}"/>
              </a:ext>
            </a:extLst>
          </p:cNvPr>
          <p:cNvSpPr/>
          <p:nvPr/>
        </p:nvSpPr>
        <p:spPr>
          <a:xfrm flipH="1">
            <a:off x="1337022" y="730304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83">
            <a:extLst>
              <a:ext uri="{FF2B5EF4-FFF2-40B4-BE49-F238E27FC236}">
                <a16:creationId xmlns:a16="http://schemas.microsoft.com/office/drawing/2014/main" id="{648777D5-6F5C-C229-1EA2-46C7A27F38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0084" y="714429"/>
            <a:ext cx="7556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T 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55">
            <a:extLst>
              <a:ext uri="{FF2B5EF4-FFF2-40B4-BE49-F238E27FC236}">
                <a16:creationId xmlns:a16="http://schemas.microsoft.com/office/drawing/2014/main" id="{D41A3061-019C-E3E9-0535-1C9576949D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247" y="715372"/>
            <a:ext cx="552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3F6A2D4-D049-C649-A532-C6B23C843839}"/>
              </a:ext>
            </a:extLst>
          </p:cNvPr>
          <p:cNvSpPr/>
          <p:nvPr/>
        </p:nvSpPr>
        <p:spPr>
          <a:xfrm>
            <a:off x="926841" y="1007035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4B281F42-92BC-F8ED-2F7D-DEEF7447768D}"/>
              </a:ext>
            </a:extLst>
          </p:cNvPr>
          <p:cNvSpPr/>
          <p:nvPr/>
        </p:nvSpPr>
        <p:spPr>
          <a:xfrm flipH="1">
            <a:off x="1334828" y="1007035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83">
            <a:extLst>
              <a:ext uri="{FF2B5EF4-FFF2-40B4-BE49-F238E27FC236}">
                <a16:creationId xmlns:a16="http://schemas.microsoft.com/office/drawing/2014/main" id="{3F18602A-31DF-212C-9051-67F725EB70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2968" y="991160"/>
            <a:ext cx="7556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55">
            <a:extLst>
              <a:ext uri="{FF2B5EF4-FFF2-40B4-BE49-F238E27FC236}">
                <a16:creationId xmlns:a16="http://schemas.microsoft.com/office/drawing/2014/main" id="{B7003ED6-33B5-BB9A-7CE8-CA88F69C88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053" y="854635"/>
            <a:ext cx="5524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 U6+27</a:t>
            </a:r>
            <a:endParaRPr lang="zh-CN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DD4EAD1-4BF6-6F2A-7FD8-AB413B9CBEAD}"/>
              </a:ext>
            </a:extLst>
          </p:cNvPr>
          <p:cNvSpPr/>
          <p:nvPr/>
        </p:nvSpPr>
        <p:spPr>
          <a:xfrm>
            <a:off x="926841" y="1288368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2ACE72A5-4027-4A50-54BA-91F21CFDE9F6}"/>
              </a:ext>
            </a:extLst>
          </p:cNvPr>
          <p:cNvSpPr/>
          <p:nvPr/>
        </p:nvSpPr>
        <p:spPr>
          <a:xfrm flipH="1">
            <a:off x="1334828" y="1288368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83">
            <a:extLst>
              <a:ext uri="{FF2B5EF4-FFF2-40B4-BE49-F238E27FC236}">
                <a16:creationId xmlns:a16="http://schemas.microsoft.com/office/drawing/2014/main" id="{27096329-3093-6906-1D30-E9ED2F746D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0960" y="1273436"/>
            <a:ext cx="82765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Pre-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55">
            <a:extLst>
              <a:ext uri="{FF2B5EF4-FFF2-40B4-BE49-F238E27FC236}">
                <a16:creationId xmlns:a16="http://schemas.microsoft.com/office/drawing/2014/main" id="{A16F44FD-AF57-1C07-1247-51C100CC58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053" y="1273436"/>
            <a:ext cx="552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C9B3D0FD-2142-4FB5-4793-68BF8486F938}"/>
              </a:ext>
            </a:extLst>
          </p:cNvPr>
          <p:cNvSpPr/>
          <p:nvPr/>
        </p:nvSpPr>
        <p:spPr>
          <a:xfrm>
            <a:off x="929067" y="1566564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126660CF-AA0C-50A8-3AE1-22545424FC63}"/>
              </a:ext>
            </a:extLst>
          </p:cNvPr>
          <p:cNvSpPr/>
          <p:nvPr/>
        </p:nvSpPr>
        <p:spPr>
          <a:xfrm flipH="1">
            <a:off x="1337054" y="1566564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83">
            <a:extLst>
              <a:ext uri="{FF2B5EF4-FFF2-40B4-BE49-F238E27FC236}">
                <a16:creationId xmlns:a16="http://schemas.microsoft.com/office/drawing/2014/main" id="{86AAC50F-4166-12B7-5A74-693FC543AD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5194" y="1550689"/>
            <a:ext cx="7556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55">
            <a:extLst>
              <a:ext uri="{FF2B5EF4-FFF2-40B4-BE49-F238E27FC236}">
                <a16:creationId xmlns:a16="http://schemas.microsoft.com/office/drawing/2014/main" id="{A0F1ECC6-971C-9C35-3E02-33967652AC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3979" y="1414164"/>
            <a:ext cx="5524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 U6+27</a:t>
            </a:r>
            <a:endParaRPr lang="zh-CN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组合 2">
            <a:extLst>
              <a:ext uri="{FF2B5EF4-FFF2-40B4-BE49-F238E27FC236}">
                <a16:creationId xmlns:a16="http://schemas.microsoft.com/office/drawing/2014/main" id="{F89C8A3A-F6BF-E002-5DC7-149D8ED413BF}"/>
              </a:ext>
            </a:extLst>
          </p:cNvPr>
          <p:cNvGrpSpPr>
            <a:grpSpLocks/>
          </p:cNvGrpSpPr>
          <p:nvPr/>
        </p:nvGrpSpPr>
        <p:grpSpPr bwMode="auto">
          <a:xfrm>
            <a:off x="396842" y="2125392"/>
            <a:ext cx="2320925" cy="242888"/>
            <a:chOff x="2644358" y="1047965"/>
            <a:chExt cx="1413509" cy="244178"/>
          </a:xfrm>
        </p:grpSpPr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1928C4AD-C62D-7A27-1DC4-F9ABDE3F1088}"/>
                </a:ext>
              </a:extLst>
            </p:cNvPr>
            <p:cNvSpPr/>
            <p:nvPr/>
          </p:nvSpPr>
          <p:spPr>
            <a:xfrm>
              <a:off x="2681098" y="1055945"/>
              <a:ext cx="397368" cy="217047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57">
              <a:extLst>
                <a:ext uri="{FF2B5EF4-FFF2-40B4-BE49-F238E27FC236}">
                  <a16:creationId xmlns:a16="http://schemas.microsoft.com/office/drawing/2014/main" id="{87C6D26C-6CE4-A606-AF20-4C106137F4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4358" y="1061311"/>
              <a:ext cx="46974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F-1α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11A6349D-6C0A-8669-2D01-8672FD3D9625}"/>
                </a:ext>
              </a:extLst>
            </p:cNvPr>
            <p:cNvSpPr/>
            <p:nvPr/>
          </p:nvSpPr>
          <p:spPr>
            <a:xfrm>
              <a:off x="3027224" y="1052753"/>
              <a:ext cx="721257" cy="21704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BDF046B3-4520-B198-FBC9-B90E4758C16C}"/>
                </a:ext>
              </a:extLst>
            </p:cNvPr>
            <p:cNvSpPr/>
            <p:nvPr/>
          </p:nvSpPr>
          <p:spPr>
            <a:xfrm flipH="1">
              <a:off x="3720443" y="1052753"/>
              <a:ext cx="215603" cy="21545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69">
              <a:extLst>
                <a:ext uri="{FF2B5EF4-FFF2-40B4-BE49-F238E27FC236}">
                  <a16:creationId xmlns:a16="http://schemas.microsoft.com/office/drawing/2014/main" id="{E15AD0A6-AC64-77F0-0CC7-AF1F9FE8E3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6809" y="1052737"/>
              <a:ext cx="883102" cy="2317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sRx-2A-mCherry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71">
              <a:extLst>
                <a:ext uri="{FF2B5EF4-FFF2-40B4-BE49-F238E27FC236}">
                  <a16:creationId xmlns:a16="http://schemas.microsoft.com/office/drawing/2014/main" id="{7EF4FD80-FCDC-3D12-969F-5644D04ADE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81954" y="1047965"/>
              <a:ext cx="475913" cy="2362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 PA</a:t>
              </a:r>
              <a:endParaRPr lang="zh-CN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文本框 3">
            <a:extLst>
              <a:ext uri="{FF2B5EF4-FFF2-40B4-BE49-F238E27FC236}">
                <a16:creationId xmlns:a16="http://schemas.microsoft.com/office/drawing/2014/main" id="{9AFE3883-6236-5316-85D0-62B9C3C8EC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424" y="1833096"/>
            <a:ext cx="15026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asRx-2A-mCherry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55127BD3-1EF3-F360-ED8F-0A874C123203}"/>
              </a:ext>
            </a:extLst>
          </p:cNvPr>
          <p:cNvSpPr/>
          <p:nvPr/>
        </p:nvSpPr>
        <p:spPr bwMode="auto">
          <a:xfrm>
            <a:off x="462024" y="2783375"/>
            <a:ext cx="652462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57">
            <a:extLst>
              <a:ext uri="{FF2B5EF4-FFF2-40B4-BE49-F238E27FC236}">
                <a16:creationId xmlns:a16="http://schemas.microsoft.com/office/drawing/2014/main" id="{184AFBF1-1061-39B9-CEFE-6EC3921B0F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180" y="2783375"/>
            <a:ext cx="771306" cy="229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G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AC316D02-DB87-20FF-DD9A-2B1DDC6614A1}"/>
              </a:ext>
            </a:extLst>
          </p:cNvPr>
          <p:cNvSpPr/>
          <p:nvPr/>
        </p:nvSpPr>
        <p:spPr bwMode="auto">
          <a:xfrm>
            <a:off x="1030349" y="2783375"/>
            <a:ext cx="1184275" cy="216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685B0797-BF34-F7F6-8A09-89D9E4C61A2A}"/>
              </a:ext>
            </a:extLst>
          </p:cNvPr>
          <p:cNvSpPr/>
          <p:nvPr/>
        </p:nvSpPr>
        <p:spPr bwMode="auto">
          <a:xfrm flipH="1">
            <a:off x="2168587" y="2783375"/>
            <a:ext cx="354012" cy="216000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69">
            <a:extLst>
              <a:ext uri="{FF2B5EF4-FFF2-40B4-BE49-F238E27FC236}">
                <a16:creationId xmlns:a16="http://schemas.microsoft.com/office/drawing/2014/main" id="{9AD936D1-E9FA-DC17-F11F-75D225F4B9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255" y="2775702"/>
            <a:ext cx="1450018" cy="2304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71">
            <a:extLst>
              <a:ext uri="{FF2B5EF4-FFF2-40B4-BE49-F238E27FC236}">
                <a16:creationId xmlns:a16="http://schemas.microsoft.com/office/drawing/2014/main" id="{B5C2887A-6720-2106-82D2-3310B80F05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4878" y="2783375"/>
            <a:ext cx="781430" cy="234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P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3">
            <a:extLst>
              <a:ext uri="{FF2B5EF4-FFF2-40B4-BE49-F238E27FC236}">
                <a16:creationId xmlns:a16="http://schemas.microsoft.com/office/drawing/2014/main" id="{E49C7387-39E3-3CA7-B8B1-8C7620BF2D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655" y="2441762"/>
            <a:ext cx="15026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AG-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1EE714AC-5C98-6210-B4D4-5EB2C8C89BC0}"/>
              </a:ext>
            </a:extLst>
          </p:cNvPr>
          <p:cNvSpPr txBox="1"/>
          <p:nvPr/>
        </p:nvSpPr>
        <p:spPr>
          <a:xfrm>
            <a:off x="5220756" y="319646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2F13F094-AF98-3781-D017-5C9A705A41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2635" y="3252826"/>
            <a:ext cx="4203699" cy="2448000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1070353C-BF41-BD7B-1762-F4F32BC43B5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35889" y="540046"/>
            <a:ext cx="2819548" cy="2556000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B829B574-F7E9-0D55-0BDA-112AEA175CA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96084" y="527419"/>
            <a:ext cx="2815365" cy="25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006522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A7C41FF-5991-AB73-B577-29785A7DB51E}"/>
              </a:ext>
            </a:extLst>
          </p:cNvPr>
          <p:cNvSpPr txBox="1"/>
          <p:nvPr/>
        </p:nvSpPr>
        <p:spPr>
          <a:xfrm>
            <a:off x="297917" y="1471656"/>
            <a:ext cx="8616007" cy="29664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9 The trans-cleavage activity of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–mediated exogenous transcripts degradation a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Experiment design for trans-cleavage activ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HEK293T cells were transiently co-transfected with 500ng plasmids (75ng CasRx-P2A-mCherry, 25ng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targeting-gRNA and 400ng CAG-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. The expression levels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were measured using FACS and fluorescence image 48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r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fter transfection, and the cleavage efficiency and trans-cleavage activity was quantified by the mean fluorescence intens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spectively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resentative bright field and fluorescence images of HEK293T cells. Scale bar, 250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,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flow cytometry analyses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HEK293T cells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d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FACS quantitative analysis of mean fluorescence intensity (MFI) of total cells. n=3,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one-way ANOVA test.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774342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矩形 30">
            <a:extLst>
              <a:ext uri="{FF2B5EF4-FFF2-40B4-BE49-F238E27FC236}">
                <a16:creationId xmlns:a16="http://schemas.microsoft.com/office/drawing/2014/main" id="{A39B0F41-111C-4AEA-4D75-FA90C4E218F1}"/>
              </a:ext>
            </a:extLst>
          </p:cNvPr>
          <p:cNvSpPr/>
          <p:nvPr/>
        </p:nvSpPr>
        <p:spPr>
          <a:xfrm>
            <a:off x="104011" y="6434628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0 The trans-cleavage activity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–mediated endogenous transcripts degradation.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627D4EF-7EC7-600E-C075-CC30D59303D1}"/>
              </a:ext>
            </a:extLst>
          </p:cNvPr>
          <p:cNvSpPr txBox="1"/>
          <p:nvPr/>
        </p:nvSpPr>
        <p:spPr>
          <a:xfrm>
            <a:off x="3555635" y="201727"/>
            <a:ext cx="9801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ight-fiel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E05FD64-16D7-AE15-A67B-9A10116A997B}"/>
              </a:ext>
            </a:extLst>
          </p:cNvPr>
          <p:cNvSpPr txBox="1"/>
          <p:nvPr/>
        </p:nvSpPr>
        <p:spPr>
          <a:xfrm>
            <a:off x="4279027" y="197148"/>
            <a:ext cx="9666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BB626EA-39FD-87BC-A9CC-D3C1B1CEBE4F}"/>
              </a:ext>
            </a:extLst>
          </p:cNvPr>
          <p:cNvSpPr txBox="1"/>
          <p:nvPr/>
        </p:nvSpPr>
        <p:spPr>
          <a:xfrm>
            <a:off x="5123548" y="200518"/>
            <a:ext cx="726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D1D890D-5C58-F92E-0930-8357FB7902A9}"/>
              </a:ext>
            </a:extLst>
          </p:cNvPr>
          <p:cNvSpPr txBox="1"/>
          <p:nvPr/>
        </p:nvSpPr>
        <p:spPr>
          <a:xfrm rot="16200000">
            <a:off x="3038180" y="548225"/>
            <a:ext cx="699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T g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D13288E-AC9A-C95A-15A2-0980A034255A}"/>
              </a:ext>
            </a:extLst>
          </p:cNvPr>
          <p:cNvSpPr txBox="1"/>
          <p:nvPr/>
        </p:nvSpPr>
        <p:spPr>
          <a:xfrm rot="16200000">
            <a:off x="3011705" y="1020517"/>
            <a:ext cx="637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6457F72-1AF5-DA27-EC36-B8A15D64BA4A}"/>
              </a:ext>
            </a:extLst>
          </p:cNvPr>
          <p:cNvSpPr txBox="1"/>
          <p:nvPr/>
        </p:nvSpPr>
        <p:spPr>
          <a:xfrm rot="16200000">
            <a:off x="2994090" y="1608060"/>
            <a:ext cx="6731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E2788CE-911D-2F53-9949-600B774FD9FB}"/>
              </a:ext>
            </a:extLst>
          </p:cNvPr>
          <p:cNvSpPr txBox="1"/>
          <p:nvPr/>
        </p:nvSpPr>
        <p:spPr>
          <a:xfrm rot="16200000">
            <a:off x="3078584" y="2153809"/>
            <a:ext cx="5041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NF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CD3DC4A-373F-79EC-65FD-99CABD7E44F9}"/>
              </a:ext>
            </a:extLst>
          </p:cNvPr>
          <p:cNvSpPr txBox="1"/>
          <p:nvPr/>
        </p:nvSpPr>
        <p:spPr>
          <a:xfrm rot="16200000">
            <a:off x="3061564" y="2703288"/>
            <a:ext cx="5403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NF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AB20684-E54D-33F3-C8C7-D9B8C98ED7E1}"/>
              </a:ext>
            </a:extLst>
          </p:cNvPr>
          <p:cNvSpPr txBox="1"/>
          <p:nvPr/>
        </p:nvSpPr>
        <p:spPr>
          <a:xfrm rot="16200000">
            <a:off x="5739152" y="537069"/>
            <a:ext cx="756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B4GALNT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B47EC9C-A867-EE1B-1D84-7AA7DC51B1F3}"/>
              </a:ext>
            </a:extLst>
          </p:cNvPr>
          <p:cNvSpPr txBox="1"/>
          <p:nvPr/>
        </p:nvSpPr>
        <p:spPr>
          <a:xfrm rot="16200000">
            <a:off x="5716720" y="1103329"/>
            <a:ext cx="809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B4GALNT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61ECB7F-A529-21C0-21A0-9AC0631B913F}"/>
              </a:ext>
            </a:extLst>
          </p:cNvPr>
          <p:cNvSpPr txBox="1"/>
          <p:nvPr/>
        </p:nvSpPr>
        <p:spPr>
          <a:xfrm rot="16200000">
            <a:off x="5828891" y="1648522"/>
            <a:ext cx="576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A48F2C1-E53C-15E9-9C60-F188E85425C2}"/>
              </a:ext>
            </a:extLst>
          </p:cNvPr>
          <p:cNvSpPr txBox="1"/>
          <p:nvPr/>
        </p:nvSpPr>
        <p:spPr>
          <a:xfrm rot="16200000">
            <a:off x="5831100" y="2199329"/>
            <a:ext cx="6109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21DA2DE-CF5B-67B4-76D8-A53CC6FE8C0E}"/>
              </a:ext>
            </a:extLst>
          </p:cNvPr>
          <p:cNvSpPr txBox="1"/>
          <p:nvPr/>
        </p:nvSpPr>
        <p:spPr>
          <a:xfrm rot="16200000">
            <a:off x="5839966" y="2754355"/>
            <a:ext cx="54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RPL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A24D219-D5C8-78ED-EC9A-1E2F4B7A2B7A}"/>
              </a:ext>
            </a:extLst>
          </p:cNvPr>
          <p:cNvSpPr txBox="1"/>
          <p:nvPr/>
        </p:nvSpPr>
        <p:spPr>
          <a:xfrm rot="16200000">
            <a:off x="5821194" y="3296499"/>
            <a:ext cx="576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-L1-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RPL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6C5A911-3EAF-024E-E93F-31C20328901B}"/>
              </a:ext>
            </a:extLst>
          </p:cNvPr>
          <p:cNvSpPr txBox="1"/>
          <p:nvPr/>
        </p:nvSpPr>
        <p:spPr>
          <a:xfrm>
            <a:off x="6308346" y="193803"/>
            <a:ext cx="850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ight-fiel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E7BEDFF-ED28-2777-D9F5-FD8E6D62861D}"/>
              </a:ext>
            </a:extLst>
          </p:cNvPr>
          <p:cNvSpPr txBox="1"/>
          <p:nvPr/>
        </p:nvSpPr>
        <p:spPr>
          <a:xfrm>
            <a:off x="7049625" y="187316"/>
            <a:ext cx="943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335B374-82B1-D4B9-9E9D-FD3D105CCF41}"/>
              </a:ext>
            </a:extLst>
          </p:cNvPr>
          <p:cNvSpPr txBox="1"/>
          <p:nvPr/>
        </p:nvSpPr>
        <p:spPr>
          <a:xfrm>
            <a:off x="7892169" y="187316"/>
            <a:ext cx="8419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B83BA33-F461-DB4E-5A52-4ED1BDE324D3}"/>
              </a:ext>
            </a:extLst>
          </p:cNvPr>
          <p:cNvSpPr txBox="1"/>
          <p:nvPr/>
        </p:nvSpPr>
        <p:spPr>
          <a:xfrm>
            <a:off x="288095" y="10947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2107A54-7A50-A484-30F0-C76A0BA169AA}"/>
              </a:ext>
            </a:extLst>
          </p:cNvPr>
          <p:cNvSpPr txBox="1"/>
          <p:nvPr/>
        </p:nvSpPr>
        <p:spPr>
          <a:xfrm>
            <a:off x="2966561" y="12863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24F0A70-6EEF-D372-F70F-53916AB790F8}"/>
              </a:ext>
            </a:extLst>
          </p:cNvPr>
          <p:cNvSpPr txBox="1"/>
          <p:nvPr/>
        </p:nvSpPr>
        <p:spPr>
          <a:xfrm>
            <a:off x="297126" y="3215816"/>
            <a:ext cx="2296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1B0AEC2-060D-72FC-F572-DA3134ECE959}"/>
              </a:ext>
            </a:extLst>
          </p:cNvPr>
          <p:cNvSpPr txBox="1"/>
          <p:nvPr/>
        </p:nvSpPr>
        <p:spPr>
          <a:xfrm>
            <a:off x="4024879" y="3768351"/>
            <a:ext cx="2296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7" name="文本框 50">
            <a:extLst>
              <a:ext uri="{FF2B5EF4-FFF2-40B4-BE49-F238E27FC236}">
                <a16:creationId xmlns:a16="http://schemas.microsoft.com/office/drawing/2014/main" id="{43A0C415-6729-29A9-C3D7-879A964DD9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4" y="629968"/>
            <a:ext cx="128251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RNAs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AE7CBDCD-F304-8818-6984-B671164D2D69}"/>
              </a:ext>
            </a:extLst>
          </p:cNvPr>
          <p:cNvSpPr/>
          <p:nvPr/>
        </p:nvSpPr>
        <p:spPr>
          <a:xfrm>
            <a:off x="994268" y="927461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FC8C6FC-F6FA-2ED3-EF03-7E66C1B37188}"/>
              </a:ext>
            </a:extLst>
          </p:cNvPr>
          <p:cNvSpPr/>
          <p:nvPr/>
        </p:nvSpPr>
        <p:spPr>
          <a:xfrm flipH="1">
            <a:off x="1402255" y="927461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83">
            <a:extLst>
              <a:ext uri="{FF2B5EF4-FFF2-40B4-BE49-F238E27FC236}">
                <a16:creationId xmlns:a16="http://schemas.microsoft.com/office/drawing/2014/main" id="{53DBD164-2A87-B1E6-30ED-A8DABCA8B2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5317" y="911586"/>
            <a:ext cx="7556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T 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55">
            <a:extLst>
              <a:ext uri="{FF2B5EF4-FFF2-40B4-BE49-F238E27FC236}">
                <a16:creationId xmlns:a16="http://schemas.microsoft.com/office/drawing/2014/main" id="{FAE44A1B-0B7F-659E-92B1-A59FD6E142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480" y="912529"/>
            <a:ext cx="552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ECB4791B-8449-601F-68BA-C707960618F2}"/>
              </a:ext>
            </a:extLst>
          </p:cNvPr>
          <p:cNvSpPr/>
          <p:nvPr/>
        </p:nvSpPr>
        <p:spPr>
          <a:xfrm>
            <a:off x="992074" y="1204192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BC015484-203F-4E8A-650A-D292B8CDE060}"/>
              </a:ext>
            </a:extLst>
          </p:cNvPr>
          <p:cNvSpPr/>
          <p:nvPr/>
        </p:nvSpPr>
        <p:spPr>
          <a:xfrm flipH="1">
            <a:off x="1400061" y="1204192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83">
            <a:extLst>
              <a:ext uri="{FF2B5EF4-FFF2-40B4-BE49-F238E27FC236}">
                <a16:creationId xmlns:a16="http://schemas.microsoft.com/office/drawing/2014/main" id="{CCAFB0CC-30AE-2D57-D4EE-DE2CE6E8C2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8201" y="1188317"/>
            <a:ext cx="7556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55">
            <a:extLst>
              <a:ext uri="{FF2B5EF4-FFF2-40B4-BE49-F238E27FC236}">
                <a16:creationId xmlns:a16="http://schemas.microsoft.com/office/drawing/2014/main" id="{1956B959-4B5B-1E45-C185-B330A63B16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4286" y="1195232"/>
            <a:ext cx="552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0F5AFD4A-4BE2-2C12-8C2A-6F7AD695BB30}"/>
              </a:ext>
            </a:extLst>
          </p:cNvPr>
          <p:cNvSpPr/>
          <p:nvPr/>
        </p:nvSpPr>
        <p:spPr>
          <a:xfrm>
            <a:off x="992074" y="1485525"/>
            <a:ext cx="431800" cy="2159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8ED5D547-ADB7-3BB9-F00A-CC4CB5EA63C7}"/>
              </a:ext>
            </a:extLst>
          </p:cNvPr>
          <p:cNvSpPr/>
          <p:nvPr/>
        </p:nvSpPr>
        <p:spPr>
          <a:xfrm flipH="1">
            <a:off x="1400061" y="1485525"/>
            <a:ext cx="649288" cy="2159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83">
            <a:extLst>
              <a:ext uri="{FF2B5EF4-FFF2-40B4-BE49-F238E27FC236}">
                <a16:creationId xmlns:a16="http://schemas.microsoft.com/office/drawing/2014/main" id="{64C9BD8A-A3ED-959E-143D-9440E1F841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6193" y="1470593"/>
            <a:ext cx="82765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Pre-gR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55">
            <a:extLst>
              <a:ext uri="{FF2B5EF4-FFF2-40B4-BE49-F238E27FC236}">
                <a16:creationId xmlns:a16="http://schemas.microsoft.com/office/drawing/2014/main" id="{A5D70ED3-6296-32CF-2769-3F08916413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4286" y="1470593"/>
            <a:ext cx="552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U6+2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组合 2">
            <a:extLst>
              <a:ext uri="{FF2B5EF4-FFF2-40B4-BE49-F238E27FC236}">
                <a16:creationId xmlns:a16="http://schemas.microsoft.com/office/drawing/2014/main" id="{B69D3CAD-D8A2-8548-53C6-779B8DC68D34}"/>
              </a:ext>
            </a:extLst>
          </p:cNvPr>
          <p:cNvGrpSpPr>
            <a:grpSpLocks/>
          </p:cNvGrpSpPr>
          <p:nvPr/>
        </p:nvGrpSpPr>
        <p:grpSpPr bwMode="auto">
          <a:xfrm>
            <a:off x="826032" y="2100151"/>
            <a:ext cx="2320925" cy="242888"/>
            <a:chOff x="2644358" y="1047965"/>
            <a:chExt cx="1413509" cy="244178"/>
          </a:xfrm>
        </p:grpSpPr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988CD7DF-A152-0466-0A26-0999663ED035}"/>
                </a:ext>
              </a:extLst>
            </p:cNvPr>
            <p:cNvSpPr/>
            <p:nvPr/>
          </p:nvSpPr>
          <p:spPr>
            <a:xfrm>
              <a:off x="2681098" y="1055945"/>
              <a:ext cx="397368" cy="217047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7">
              <a:extLst>
                <a:ext uri="{FF2B5EF4-FFF2-40B4-BE49-F238E27FC236}">
                  <a16:creationId xmlns:a16="http://schemas.microsoft.com/office/drawing/2014/main" id="{C1E5B6CC-6855-CA5F-05D3-2AF3ED3EEE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4358" y="1061311"/>
              <a:ext cx="46974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F-1α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136FAC39-D4DC-2881-9F02-D5DB2733970E}"/>
                </a:ext>
              </a:extLst>
            </p:cNvPr>
            <p:cNvSpPr/>
            <p:nvPr/>
          </p:nvSpPr>
          <p:spPr>
            <a:xfrm>
              <a:off x="3027224" y="1052753"/>
              <a:ext cx="721257" cy="21704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49DE11A1-65F5-AE53-72B5-4B26143B7DD5}"/>
                </a:ext>
              </a:extLst>
            </p:cNvPr>
            <p:cNvSpPr/>
            <p:nvPr/>
          </p:nvSpPr>
          <p:spPr>
            <a:xfrm flipH="1">
              <a:off x="3720443" y="1052753"/>
              <a:ext cx="215603" cy="21545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69">
              <a:extLst>
                <a:ext uri="{FF2B5EF4-FFF2-40B4-BE49-F238E27FC236}">
                  <a16:creationId xmlns:a16="http://schemas.microsoft.com/office/drawing/2014/main" id="{118B2A5E-E0F7-4A66-0F1D-2DD89770CC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6809" y="1052737"/>
              <a:ext cx="883102" cy="2317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sRx-2A-mCherry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71">
              <a:extLst>
                <a:ext uri="{FF2B5EF4-FFF2-40B4-BE49-F238E27FC236}">
                  <a16:creationId xmlns:a16="http://schemas.microsoft.com/office/drawing/2014/main" id="{93E55D8E-7D69-57DB-3AD8-4E91DDFDAF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81954" y="1047965"/>
              <a:ext cx="475913" cy="2362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Wingdings 2" panose="05020102010507070707" pitchFamily="18" charset="2"/>
                <a:buChar char="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 PA</a:t>
              </a:r>
              <a:endParaRPr lang="zh-CN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文本框 3">
            <a:extLst>
              <a:ext uri="{FF2B5EF4-FFF2-40B4-BE49-F238E27FC236}">
                <a16:creationId xmlns:a16="http://schemas.microsoft.com/office/drawing/2014/main" id="{190A7041-8DDB-D9A5-2725-8F663E683E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4474" y="1769845"/>
            <a:ext cx="15026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asRx-2A-mCherry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3">
            <a:extLst>
              <a:ext uri="{FF2B5EF4-FFF2-40B4-BE49-F238E27FC236}">
                <a16:creationId xmlns:a16="http://schemas.microsoft.com/office/drawing/2014/main" id="{C53AF282-8EFD-EAE5-614D-A2CB64DC75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765" y="2323980"/>
            <a:ext cx="15026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AG-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9A865816-191B-542F-70DE-677E406CC558}"/>
              </a:ext>
            </a:extLst>
          </p:cNvPr>
          <p:cNvSpPr/>
          <p:nvPr/>
        </p:nvSpPr>
        <p:spPr bwMode="auto">
          <a:xfrm>
            <a:off x="883207" y="2613780"/>
            <a:ext cx="652462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57">
            <a:extLst>
              <a:ext uri="{FF2B5EF4-FFF2-40B4-BE49-F238E27FC236}">
                <a16:creationId xmlns:a16="http://schemas.microsoft.com/office/drawing/2014/main" id="{90A398BC-D21B-8D0B-E471-C29CC4CAC6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4363" y="2613780"/>
            <a:ext cx="771306" cy="229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G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C0C06410-A2BF-A75F-497D-B19993A6F700}"/>
              </a:ext>
            </a:extLst>
          </p:cNvPr>
          <p:cNvSpPr/>
          <p:nvPr/>
        </p:nvSpPr>
        <p:spPr bwMode="auto">
          <a:xfrm>
            <a:off x="1451532" y="2613780"/>
            <a:ext cx="1184275" cy="216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4B97F398-9811-0086-D80A-9426455DB6C0}"/>
              </a:ext>
            </a:extLst>
          </p:cNvPr>
          <p:cNvSpPr/>
          <p:nvPr/>
        </p:nvSpPr>
        <p:spPr bwMode="auto">
          <a:xfrm flipH="1">
            <a:off x="2589770" y="2613780"/>
            <a:ext cx="354012" cy="216000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69">
            <a:extLst>
              <a:ext uri="{FF2B5EF4-FFF2-40B4-BE49-F238E27FC236}">
                <a16:creationId xmlns:a16="http://schemas.microsoft.com/office/drawing/2014/main" id="{B08A97A8-C36B-D877-BD6D-A2149E0E9D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9438" y="2606107"/>
            <a:ext cx="1450018" cy="2304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1">
            <a:extLst>
              <a:ext uri="{FF2B5EF4-FFF2-40B4-BE49-F238E27FC236}">
                <a16:creationId xmlns:a16="http://schemas.microsoft.com/office/drawing/2014/main" id="{C8DD07D4-C9F8-211C-CEA2-A86A2F4A45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6061" y="2613780"/>
            <a:ext cx="781430" cy="234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Wingdings 2" panose="05020102010507070707" pitchFamily="18" charset="2"/>
              <a:buChar char="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P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F92F28AB-E65D-785D-764F-32FE033AD1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1003" y="436405"/>
            <a:ext cx="2340000" cy="2712363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5647AC5A-46B6-41B3-3C61-42E75E7753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1084" y="456603"/>
            <a:ext cx="2340000" cy="3270929"/>
          </a:xfrm>
          <a:prstGeom prst="rect">
            <a:avLst/>
          </a:prstGeom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AE7274A5-A079-8A84-B1C7-9D993FAA23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6355" y="4135680"/>
            <a:ext cx="2344988" cy="2207605"/>
          </a:xfrm>
          <a:prstGeom prst="rect">
            <a:avLst/>
          </a:prstGeom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B072A304-2A76-615E-36EF-797EB0C5D7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59309" y="4135680"/>
            <a:ext cx="2337810" cy="220084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C88A5E1-4B8E-3E72-7774-C758D3519E80}"/>
              </a:ext>
            </a:extLst>
          </p:cNvPr>
          <p:cNvSpPr txBox="1"/>
          <p:nvPr/>
        </p:nvSpPr>
        <p:spPr>
          <a:xfrm>
            <a:off x="1376450" y="6170953"/>
            <a:ext cx="1304898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50" b="1" dirty="0">
                <a:latin typeface="Arial" panose="020B0604020202020204" pitchFamily="34" charset="0"/>
                <a:cs typeface="Arial" panose="020B0604020202020204" pitchFamily="34" charset="0"/>
              </a:rPr>
              <a:t>mNeonGreen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939B461-DC88-5EA5-E09E-706922E03D12}"/>
              </a:ext>
            </a:extLst>
          </p:cNvPr>
          <p:cNvSpPr txBox="1"/>
          <p:nvPr/>
        </p:nvSpPr>
        <p:spPr>
          <a:xfrm rot="16200000">
            <a:off x="108" y="4950887"/>
            <a:ext cx="904973" cy="3770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50" b="1" dirty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zh-CN" altLang="en-US" sz="9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7847B014-BA4E-2EAA-86AF-4187EBDC6141}"/>
              </a:ext>
            </a:extLst>
          </p:cNvPr>
          <p:cNvCxnSpPr>
            <a:cxnSpLocks/>
          </p:cNvCxnSpPr>
          <p:nvPr/>
        </p:nvCxnSpPr>
        <p:spPr>
          <a:xfrm>
            <a:off x="750090" y="6215909"/>
            <a:ext cx="1931258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3280DAC-9A1E-7CF5-C400-418DA5F88DC5}"/>
              </a:ext>
            </a:extLst>
          </p:cNvPr>
          <p:cNvCxnSpPr>
            <a:cxnSpLocks/>
          </p:cNvCxnSpPr>
          <p:nvPr/>
        </p:nvCxnSpPr>
        <p:spPr>
          <a:xfrm flipV="1">
            <a:off x="498233" y="4509933"/>
            <a:ext cx="0" cy="161251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图片 20">
            <a:extLst>
              <a:ext uri="{FF2B5EF4-FFF2-40B4-BE49-F238E27FC236}">
                <a16:creationId xmlns:a16="http://schemas.microsoft.com/office/drawing/2014/main" id="{FACED4C6-EE8B-8640-7DB9-853DA773DB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3404" y="3265952"/>
            <a:ext cx="3412898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656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1DBAF6A9-6051-2698-5387-841C33C7F348}"/>
              </a:ext>
            </a:extLst>
          </p:cNvPr>
          <p:cNvSpPr txBox="1"/>
          <p:nvPr/>
        </p:nvSpPr>
        <p:spPr>
          <a:xfrm>
            <a:off x="346587" y="1183858"/>
            <a:ext cx="8450826" cy="29664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1 Establishment of the d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knock-in HEK293T cell line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Schematic of the DNA donor and targeting strategy at the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AVS1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locus. Filled boxes with numbers indicate exons. gRNA indicates the gAAVS1 target site in the donor. T2A, </a:t>
            </a:r>
            <a:r>
              <a:rPr lang="en-US" altLang="zh-CN" sz="14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hoseaasign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virus 2A self-cleaving peptide; puro, puromycin resistant gene; PA,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oly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; M2rtTA, reverse tetracycline-controlle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ransactivator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; CAG, CAG promoter;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, nuclease-deficient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fused with the p300 core domain; TRE, TRE promoter containing tetracycline-responsive element; HITI, Homology Independent Target Integration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amp;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he inducible expression of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in the KI cell line. The cells were treated with or without 2ug/ml Doxycycline (Dox) for 48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r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RNA and protein were harvested for quantitative RT-PCR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 and Western Blotting (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 assays, respectively.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139332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93F6979-8983-FFBD-E3E5-611A5AC14A3F}"/>
              </a:ext>
            </a:extLst>
          </p:cNvPr>
          <p:cNvSpPr txBox="1"/>
          <p:nvPr/>
        </p:nvSpPr>
        <p:spPr>
          <a:xfrm>
            <a:off x="356911" y="1725787"/>
            <a:ext cx="8430178" cy="23201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10 The trans-cleavage activity of </a:t>
            </a:r>
            <a:r>
              <a:rPr lang="en-US" altLang="zh-CN" sz="14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–mediated endogenous transcripts degradation. a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Experiment design for trans-cleavage activ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Rx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HEK293T cells were transiently co-transfected with CasRx-P2A-mCherry, CAG-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endogenous-targeting-gRNA plasmids (gSTAT3, gNF2, gB4GALNT1,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gKRAS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and gRPL4), The trans-cleavage activity was quantified by the fluorescence intens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resentative bright field and fluorescence images of the transfected HEK293T cells. Scale bar, 250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-d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Flow cytometry analyses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n the transfected HEK293T cells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n=3,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one-way ANOVA tes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19616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图片 1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3567719" y="2575644"/>
            <a:ext cx="1188205" cy="1476000"/>
          </a:xfrm>
          <a:prstGeom prst="rect">
            <a:avLst/>
          </a:prstGeom>
        </p:spPr>
      </p:pic>
      <p:sp>
        <p:nvSpPr>
          <p:cNvPr id="41" name="矩形 40"/>
          <p:cNvSpPr/>
          <p:nvPr/>
        </p:nvSpPr>
        <p:spPr>
          <a:xfrm>
            <a:off x="161848" y="6407724"/>
            <a:ext cx="87191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1 The structures of circular gRNAs for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 with different linkers targeting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L1RN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redicted by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37" y="1314640"/>
            <a:ext cx="3354219" cy="46127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04009" y="1395892"/>
            <a:ext cx="92303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s12a gRNA scaffold</a:t>
            </a:r>
            <a:endParaRPr lang="zh-CN" altLang="en-US" sz="900" dirty="0"/>
          </a:p>
        </p:txBody>
      </p:sp>
      <p:sp>
        <p:nvSpPr>
          <p:cNvPr id="58" name="文本框 57"/>
          <p:cNvSpPr txBox="1"/>
          <p:nvPr/>
        </p:nvSpPr>
        <p:spPr>
          <a:xfrm>
            <a:off x="1983582" y="1794989"/>
            <a:ext cx="87320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s12a gRNA scaffold</a:t>
            </a:r>
            <a:endParaRPr lang="zh-CN" altLang="en-US" sz="900" dirty="0"/>
          </a:p>
        </p:txBody>
      </p:sp>
      <p:sp>
        <p:nvSpPr>
          <p:cNvPr id="59" name="文本框 58"/>
          <p:cNvSpPr txBox="1"/>
          <p:nvPr/>
        </p:nvSpPr>
        <p:spPr>
          <a:xfrm>
            <a:off x="1642952" y="1053925"/>
            <a:ext cx="6401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endParaRPr lang="zh-CN" altLang="en-US" sz="900" dirty="0"/>
          </a:p>
        </p:txBody>
      </p:sp>
      <p:cxnSp>
        <p:nvCxnSpPr>
          <p:cNvPr id="12" name="直接箭头连接符 11"/>
          <p:cNvCxnSpPr/>
          <p:nvPr/>
        </p:nvCxnSpPr>
        <p:spPr>
          <a:xfrm>
            <a:off x="895275" y="1576966"/>
            <a:ext cx="2014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 flipH="1">
            <a:off x="1551827" y="1240171"/>
            <a:ext cx="170596" cy="1356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箭头连接符 60"/>
          <p:cNvCxnSpPr/>
          <p:nvPr/>
        </p:nvCxnSpPr>
        <p:spPr>
          <a:xfrm flipH="1" flipV="1">
            <a:off x="1916365" y="1899999"/>
            <a:ext cx="279634" cy="1364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文本框 61"/>
          <p:cNvSpPr txBox="1"/>
          <p:nvPr/>
        </p:nvSpPr>
        <p:spPr>
          <a:xfrm>
            <a:off x="156252" y="2789750"/>
            <a:ext cx="9154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1 </a:t>
            </a:r>
            <a:endParaRPr lang="zh-CN" altLang="en-US" sz="900" dirty="0"/>
          </a:p>
        </p:txBody>
      </p:sp>
      <p:cxnSp>
        <p:nvCxnSpPr>
          <p:cNvPr id="64" name="直接箭头连接符 63"/>
          <p:cNvCxnSpPr/>
          <p:nvPr/>
        </p:nvCxnSpPr>
        <p:spPr>
          <a:xfrm flipV="1">
            <a:off x="782805" y="2653636"/>
            <a:ext cx="197138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箭头连接符 64"/>
          <p:cNvCxnSpPr/>
          <p:nvPr/>
        </p:nvCxnSpPr>
        <p:spPr>
          <a:xfrm flipH="1" flipV="1">
            <a:off x="2116101" y="2746218"/>
            <a:ext cx="260215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1891815" y="2915762"/>
            <a:ext cx="861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2 </a:t>
            </a:r>
            <a:endParaRPr lang="zh-CN" altLang="en-US" sz="900" dirty="0"/>
          </a:p>
        </p:txBody>
      </p:sp>
      <p:cxnSp>
        <p:nvCxnSpPr>
          <p:cNvPr id="67" name="直接箭头连接符 66"/>
          <p:cNvCxnSpPr/>
          <p:nvPr/>
        </p:nvCxnSpPr>
        <p:spPr>
          <a:xfrm>
            <a:off x="1023568" y="4636699"/>
            <a:ext cx="169553" cy="1909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箭头连接符 68"/>
          <p:cNvCxnSpPr/>
          <p:nvPr/>
        </p:nvCxnSpPr>
        <p:spPr>
          <a:xfrm flipV="1">
            <a:off x="1877566" y="4975416"/>
            <a:ext cx="221916" cy="2044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矩形 70"/>
          <p:cNvSpPr/>
          <p:nvPr/>
        </p:nvSpPr>
        <p:spPr>
          <a:xfrm>
            <a:off x="379762" y="4245490"/>
            <a:ext cx="1040904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′ P3 Twister U2A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51281" y="16039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204010" y="668551"/>
            <a:ext cx="232468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ircular gRNA with Sp1 linker</a:t>
            </a:r>
          </a:p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= - 126.10  kcal/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2977978" y="250645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2994047" y="224523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3081325" y="416721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5036212" y="245079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5037500" y="2242669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5036211" y="4109868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6978997" y="245078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7138594" y="2239665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图片 8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341267" y="685252"/>
            <a:ext cx="1353478" cy="1476000"/>
          </a:xfrm>
          <a:prstGeom prst="rect">
            <a:avLst/>
          </a:prstGeom>
        </p:spPr>
      </p:pic>
      <p:sp>
        <p:nvSpPr>
          <p:cNvPr id="91" name="文本框 90"/>
          <p:cNvSpPr txBox="1"/>
          <p:nvPr/>
        </p:nvSpPr>
        <p:spPr>
          <a:xfrm>
            <a:off x="2981094" y="339519"/>
            <a:ext cx="2260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07.0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4916389" y="347868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4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40.4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/>
          <p:cNvSpPr txBox="1"/>
          <p:nvPr/>
        </p:nvSpPr>
        <p:spPr>
          <a:xfrm>
            <a:off x="2902779" y="2328399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2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26.1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2981094" y="4271383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3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104.7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0" name="文本框 99"/>
          <p:cNvSpPr txBox="1"/>
          <p:nvPr/>
        </p:nvSpPr>
        <p:spPr>
          <a:xfrm>
            <a:off x="4981918" y="2328399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5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96.6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6893388" y="356354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7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10.7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7079120" y="2328399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09.7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4973872" y="4286493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6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04.3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5" name="图片 1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3497680" y="4633221"/>
            <a:ext cx="1412173" cy="1476000"/>
          </a:xfrm>
          <a:prstGeom prst="rect">
            <a:avLst/>
          </a:prstGeom>
        </p:spPr>
      </p:pic>
      <p:sp>
        <p:nvSpPr>
          <p:cNvPr id="118" name="矩形 117"/>
          <p:cNvSpPr/>
          <p:nvPr/>
        </p:nvSpPr>
        <p:spPr>
          <a:xfrm>
            <a:off x="1316332" y="5168201"/>
            <a:ext cx="902877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′ P1 Twister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9" name="图片 1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37801" y="743699"/>
            <a:ext cx="1395204" cy="1476000"/>
          </a:xfrm>
          <a:prstGeom prst="rect">
            <a:avLst/>
          </a:prstGeom>
        </p:spPr>
      </p:pic>
      <p:pic>
        <p:nvPicPr>
          <p:cNvPr id="121" name="图片 1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14800" y="774097"/>
            <a:ext cx="1519217" cy="1512000"/>
          </a:xfrm>
          <a:prstGeom prst="rect">
            <a:avLst/>
          </a:prstGeom>
        </p:spPr>
      </p:pic>
      <p:pic>
        <p:nvPicPr>
          <p:cNvPr id="122" name="图片 12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5436595" y="4615045"/>
            <a:ext cx="1412526" cy="1512000"/>
          </a:xfrm>
          <a:prstGeom prst="rect">
            <a:avLst/>
          </a:prstGeom>
        </p:spPr>
      </p:pic>
      <p:pic>
        <p:nvPicPr>
          <p:cNvPr id="123" name="图片 12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16200000">
            <a:off x="5415883" y="2662029"/>
            <a:ext cx="1335224" cy="1512000"/>
          </a:xfrm>
          <a:prstGeom prst="rect">
            <a:avLst/>
          </a:prstGeom>
        </p:spPr>
      </p:pic>
      <p:pic>
        <p:nvPicPr>
          <p:cNvPr id="124" name="图片 12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416854" y="2738218"/>
            <a:ext cx="1464165" cy="15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22110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93F6979-8983-FFBD-E3E5-611A5AC14A3F}"/>
              </a:ext>
            </a:extLst>
          </p:cNvPr>
          <p:cNvSpPr txBox="1"/>
          <p:nvPr/>
        </p:nvSpPr>
        <p:spPr>
          <a:xfrm>
            <a:off x="356911" y="1725787"/>
            <a:ext cx="8430178" cy="11351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1 The structures of circular gRNAs for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as12a with different linkers targeting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predicted by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-g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he predicted structure of circular gRNAs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as12a with Sp1 linker, linker1, linker2, linker3, linker4, linker5, linker6, linker7 and linker8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16895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5963" y="1027800"/>
            <a:ext cx="3012696" cy="474677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48146" y="1369767"/>
            <a:ext cx="92303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s12a gRNA scaffold</a:t>
            </a:r>
            <a:endParaRPr lang="zh-CN" altLang="en-US" sz="900" dirty="0"/>
          </a:p>
        </p:txBody>
      </p:sp>
      <p:sp>
        <p:nvSpPr>
          <p:cNvPr id="7" name="文本框 6"/>
          <p:cNvSpPr txBox="1"/>
          <p:nvPr/>
        </p:nvSpPr>
        <p:spPr>
          <a:xfrm>
            <a:off x="2427719" y="1768864"/>
            <a:ext cx="87320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s12a gRNA scaffold</a:t>
            </a:r>
            <a:endParaRPr lang="zh-CN" altLang="en-US" sz="900" dirty="0"/>
          </a:p>
        </p:txBody>
      </p:sp>
      <p:sp>
        <p:nvSpPr>
          <p:cNvPr id="8" name="文本框 7"/>
          <p:cNvSpPr txBox="1"/>
          <p:nvPr/>
        </p:nvSpPr>
        <p:spPr>
          <a:xfrm>
            <a:off x="2181063" y="1350255"/>
            <a:ext cx="6401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endParaRPr lang="zh-CN" altLang="en-US" sz="900" dirty="0"/>
          </a:p>
        </p:txBody>
      </p:sp>
      <p:cxnSp>
        <p:nvCxnSpPr>
          <p:cNvPr id="9" name="直接箭头连接符 8"/>
          <p:cNvCxnSpPr/>
          <p:nvPr/>
        </p:nvCxnSpPr>
        <p:spPr>
          <a:xfrm>
            <a:off x="1339412" y="1550841"/>
            <a:ext cx="2014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 flipH="1">
            <a:off x="2089938" y="1536501"/>
            <a:ext cx="170596" cy="1356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 flipH="1" flipV="1">
            <a:off x="2360502" y="1873874"/>
            <a:ext cx="279634" cy="1364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600389" y="2763625"/>
            <a:ext cx="9154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1 </a:t>
            </a:r>
            <a:endParaRPr lang="zh-CN" altLang="en-US" sz="900" dirty="0"/>
          </a:p>
        </p:txBody>
      </p:sp>
      <p:cxnSp>
        <p:nvCxnSpPr>
          <p:cNvPr id="13" name="直接箭头连接符 12"/>
          <p:cNvCxnSpPr/>
          <p:nvPr/>
        </p:nvCxnSpPr>
        <p:spPr>
          <a:xfrm flipV="1">
            <a:off x="1226942" y="2627511"/>
            <a:ext cx="197138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 flipH="1" flipV="1">
            <a:off x="2560238" y="2720093"/>
            <a:ext cx="260215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2335952" y="2889637"/>
            <a:ext cx="861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2 </a:t>
            </a:r>
            <a:endParaRPr lang="zh-CN" altLang="en-US" sz="900" dirty="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444699" y="4523210"/>
            <a:ext cx="169553" cy="1909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 flipV="1">
            <a:off x="2449280" y="4937616"/>
            <a:ext cx="221916" cy="2044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706490" y="4218777"/>
            <a:ext cx="1040904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′ P3 Twister U2A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23300" y="456380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48147" y="642426"/>
            <a:ext cx="232468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ircular gRNA with Sp1 linker</a:t>
            </a:r>
          </a:p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= - 126.40  kcal/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1847379" y="5093921"/>
            <a:ext cx="902877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′ P1 Twister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345245" y="46900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423867" y="2911289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062521" y="46486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161419" y="2891668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348361" y="557882"/>
            <a:ext cx="2260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08.5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6041596" y="299445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4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30.5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332599" y="299445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2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07.9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962290" y="56902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3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106.2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3723057" y="994066"/>
            <a:ext cx="1573293" cy="1620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684030" y="3485301"/>
            <a:ext cx="1604162" cy="162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6237668" y="1043292"/>
            <a:ext cx="1636085" cy="1620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01172" y="3473921"/>
            <a:ext cx="1386593" cy="1620000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212415" y="6149817"/>
            <a:ext cx="87191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2 The structures of circular gRNAs for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 with different linkers targeting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predicted by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566614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93F6979-8983-FFBD-E3E5-611A5AC14A3F}"/>
              </a:ext>
            </a:extLst>
          </p:cNvPr>
          <p:cNvSpPr txBox="1"/>
          <p:nvPr/>
        </p:nvSpPr>
        <p:spPr>
          <a:xfrm>
            <a:off x="356911" y="1725787"/>
            <a:ext cx="8430178" cy="11351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2 The structures of circular gRNAs for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as12a with different linkers targeting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predicted by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-g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he predicted structure of circular gRNAs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as12a with Sp1 linker, linker1, linker2, linker3 and linker4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294223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8818" y="969137"/>
            <a:ext cx="1649143" cy="201420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217" y="1063845"/>
            <a:ext cx="2777144" cy="455142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95328" y="1446042"/>
            <a:ext cx="92303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RNA scaffold</a:t>
            </a:r>
            <a:endParaRPr lang="zh-CN" altLang="en-US" sz="900" dirty="0"/>
          </a:p>
        </p:txBody>
      </p:sp>
      <p:sp>
        <p:nvSpPr>
          <p:cNvPr id="7" name="文本框 6"/>
          <p:cNvSpPr txBox="1"/>
          <p:nvPr/>
        </p:nvSpPr>
        <p:spPr>
          <a:xfrm>
            <a:off x="2298839" y="1470410"/>
            <a:ext cx="87320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gRNA scaffold</a:t>
            </a:r>
            <a:endParaRPr lang="zh-CN" altLang="en-US" sz="900" dirty="0"/>
          </a:p>
        </p:txBody>
      </p:sp>
      <p:sp>
        <p:nvSpPr>
          <p:cNvPr id="8" name="文本框 7"/>
          <p:cNvSpPr txBox="1"/>
          <p:nvPr/>
        </p:nvSpPr>
        <p:spPr>
          <a:xfrm>
            <a:off x="1781227" y="1029094"/>
            <a:ext cx="6401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endParaRPr lang="zh-CN" altLang="en-US" sz="900" dirty="0"/>
          </a:p>
        </p:txBody>
      </p:sp>
      <p:cxnSp>
        <p:nvCxnSpPr>
          <p:cNvPr id="9" name="直接箭头连接符 8"/>
          <p:cNvCxnSpPr/>
          <p:nvPr/>
        </p:nvCxnSpPr>
        <p:spPr>
          <a:xfrm>
            <a:off x="886594" y="1627116"/>
            <a:ext cx="2014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 flipH="1">
            <a:off x="1812216" y="1215340"/>
            <a:ext cx="170596" cy="1356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 flipH="1" flipV="1">
            <a:off x="2231622" y="1575420"/>
            <a:ext cx="279634" cy="1364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301670" y="2764334"/>
            <a:ext cx="9154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1 </a:t>
            </a:r>
            <a:endParaRPr lang="zh-CN" altLang="en-US" sz="900" dirty="0"/>
          </a:p>
        </p:txBody>
      </p:sp>
      <p:cxnSp>
        <p:nvCxnSpPr>
          <p:cNvPr id="13" name="直接箭头连接符 12"/>
          <p:cNvCxnSpPr/>
          <p:nvPr/>
        </p:nvCxnSpPr>
        <p:spPr>
          <a:xfrm flipV="1">
            <a:off x="928223" y="2628220"/>
            <a:ext cx="197138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 flipH="1" flipV="1">
            <a:off x="2262556" y="2664065"/>
            <a:ext cx="260215" cy="20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2038270" y="2833609"/>
            <a:ext cx="861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p1 linker-2 </a:t>
            </a:r>
            <a:endParaRPr lang="zh-CN" altLang="en-US" sz="900" dirty="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163916" y="4468203"/>
            <a:ext cx="169553" cy="1909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 flipV="1">
            <a:off x="2101280" y="4946286"/>
            <a:ext cx="221916" cy="2044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425707" y="4163770"/>
            <a:ext cx="1040904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′ P3 Twister U2A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23300" y="456380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48147" y="642426"/>
            <a:ext cx="232468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ircular gRNA with Sp1 linker</a:t>
            </a:r>
          </a:p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= - 148.9  kcal/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1499379" y="5102591"/>
            <a:ext cx="902877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′ P1 Twister ribozyme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345245" y="46900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345245" y="2894450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062521" y="46486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161419" y="2891668"/>
            <a:ext cx="316619" cy="282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348361" y="557882"/>
            <a:ext cx="2260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34.9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6041596" y="299445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4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35.2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332599" y="299445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2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 130.9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962290" y="569027"/>
            <a:ext cx="2259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ircular gRNA with linker3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d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-125.80  kcal/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61848" y="6204528"/>
            <a:ext cx="87191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3 The structures of circular gRNAs for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with different linkers targeting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predicted by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4687" y="1024673"/>
            <a:ext cx="1794311" cy="184632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9418" y="3518031"/>
            <a:ext cx="1870577" cy="2106455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28900" y="3389024"/>
            <a:ext cx="1676643" cy="2147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712092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93F6979-8983-FFBD-E3E5-611A5AC14A3F}"/>
              </a:ext>
            </a:extLst>
          </p:cNvPr>
          <p:cNvSpPr txBox="1"/>
          <p:nvPr/>
        </p:nvSpPr>
        <p:spPr>
          <a:xfrm>
            <a:off x="356911" y="1725787"/>
            <a:ext cx="8020173" cy="11351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2 The structures of circular gRNAs for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with different linkers targeting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predicted by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Fold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-g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he predicted structure of circular gRNAs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asRx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with Sp1 linker, linker1, linker2, linker3 and linker4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78999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文本框 184"/>
          <p:cNvSpPr txBox="1"/>
          <p:nvPr/>
        </p:nvSpPr>
        <p:spPr>
          <a:xfrm>
            <a:off x="368160" y="47825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矩形 250"/>
          <p:cNvSpPr/>
          <p:nvPr/>
        </p:nvSpPr>
        <p:spPr>
          <a:xfrm>
            <a:off x="497396" y="6019974"/>
            <a:ext cx="80303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 Circular gRNAs increase the transcription efficiency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-based activators.</a:t>
            </a:r>
          </a:p>
        </p:txBody>
      </p:sp>
      <p:sp>
        <p:nvSpPr>
          <p:cNvPr id="92" name="文本框 91"/>
          <p:cNvSpPr txBox="1"/>
          <p:nvPr/>
        </p:nvSpPr>
        <p:spPr>
          <a:xfrm>
            <a:off x="368160" y="383780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2"/>
          <a:srcRect l="-1" r="-625"/>
          <a:stretch/>
        </p:blipFill>
        <p:spPr>
          <a:xfrm>
            <a:off x="555371" y="3955684"/>
            <a:ext cx="8560767" cy="204159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125B1AFC-ECF2-F406-EE8F-5DD9D5585BF6}"/>
              </a:ext>
            </a:extLst>
          </p:cNvPr>
          <p:cNvSpPr txBox="1"/>
          <p:nvPr/>
        </p:nvSpPr>
        <p:spPr>
          <a:xfrm>
            <a:off x="2040103" y="59653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011DC06F-57E8-AF11-F006-73885008F30C}"/>
              </a:ext>
            </a:extLst>
          </p:cNvPr>
          <p:cNvGrpSpPr/>
          <p:nvPr/>
        </p:nvGrpSpPr>
        <p:grpSpPr>
          <a:xfrm>
            <a:off x="574985" y="2075197"/>
            <a:ext cx="1361679" cy="1715337"/>
            <a:chOff x="609253" y="296171"/>
            <a:chExt cx="1361679" cy="1715337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90A56932-D573-CD8D-AF71-6ADB286C35E5}"/>
                </a:ext>
              </a:extLst>
            </p:cNvPr>
            <p:cNvGrpSpPr/>
            <p:nvPr/>
          </p:nvGrpSpPr>
          <p:grpSpPr>
            <a:xfrm>
              <a:off x="609253" y="296171"/>
              <a:ext cx="1315819" cy="1536216"/>
              <a:chOff x="5268322" y="950717"/>
              <a:chExt cx="1315819" cy="1536216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C8941289-3A9F-F186-8434-E5B5DE401B81}"/>
                  </a:ext>
                </a:extLst>
              </p:cNvPr>
              <p:cNvSpPr txBox="1"/>
              <p:nvPr/>
            </p:nvSpPr>
            <p:spPr>
              <a:xfrm>
                <a:off x="5817427" y="953347"/>
                <a:ext cx="7667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L1RN</a:t>
                </a:r>
                <a:endParaRPr lang="zh-CN" altLang="en-US" sz="105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5BFB02A-4DD4-4D25-79B6-7017D3361BCE}"/>
                  </a:ext>
                </a:extLst>
              </p:cNvPr>
              <p:cNvSpPr txBox="1"/>
              <p:nvPr/>
            </p:nvSpPr>
            <p:spPr>
              <a:xfrm>
                <a:off x="5801225" y="1201985"/>
                <a:ext cx="426409" cy="228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zh-CN" alt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12" name="直接连接符 11">
                <a:extLst>
                  <a:ext uri="{FF2B5EF4-FFF2-40B4-BE49-F238E27FC236}">
                    <a16:creationId xmlns:a16="http://schemas.microsoft.com/office/drawing/2014/main" id="{1E2546E6-4167-48CD-431A-518B3DB77AEA}"/>
                  </a:ext>
                </a:extLst>
              </p:cNvPr>
              <p:cNvCxnSpPr/>
              <p:nvPr/>
            </p:nvCxnSpPr>
            <p:spPr>
              <a:xfrm flipV="1">
                <a:off x="5817427" y="1337793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39030AF2-339B-D818-FF99-EA03949757EB}"/>
                  </a:ext>
                </a:extLst>
              </p:cNvPr>
              <p:cNvSpPr txBox="1"/>
              <p:nvPr/>
            </p:nvSpPr>
            <p:spPr>
              <a:xfrm>
                <a:off x="5932314" y="1131475"/>
                <a:ext cx="426409" cy="228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zh-CN" alt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15" name="直接连接符 14">
                <a:extLst>
                  <a:ext uri="{FF2B5EF4-FFF2-40B4-BE49-F238E27FC236}">
                    <a16:creationId xmlns:a16="http://schemas.microsoft.com/office/drawing/2014/main" id="{D72AB4A8-1C08-D17E-F156-C4FC6FF4BCA9}"/>
                  </a:ext>
                </a:extLst>
              </p:cNvPr>
              <p:cNvCxnSpPr/>
              <p:nvPr/>
            </p:nvCxnSpPr>
            <p:spPr>
              <a:xfrm flipV="1">
                <a:off x="5817427" y="1259380"/>
                <a:ext cx="61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79337F39-8E9C-A664-696A-4A44805DE1DF}"/>
                  </a:ext>
                </a:extLst>
              </p:cNvPr>
              <p:cNvSpPr txBox="1"/>
              <p:nvPr/>
            </p:nvSpPr>
            <p:spPr>
              <a:xfrm rot="16200000">
                <a:off x="4611783" y="1607256"/>
                <a:ext cx="1536216" cy="2231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5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mRNA expression</a:t>
                </a:r>
                <a:endParaRPr lang="zh-CN" altLang="en-US" sz="8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F998B8E4-1EE4-66C7-8536-A66C52D366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703" t="13396" r="50000" b="12642"/>
            <a:stretch/>
          </p:blipFill>
          <p:spPr>
            <a:xfrm>
              <a:off x="805218" y="571508"/>
              <a:ext cx="1165714" cy="1440000"/>
            </a:xfrm>
            <a:prstGeom prst="rect">
              <a:avLst/>
            </a:prstGeom>
          </p:spPr>
        </p:pic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CD0B5D03-DE1B-262A-C78C-C124AF9323AC}"/>
              </a:ext>
            </a:extLst>
          </p:cNvPr>
          <p:cNvGrpSpPr/>
          <p:nvPr/>
        </p:nvGrpSpPr>
        <p:grpSpPr>
          <a:xfrm>
            <a:off x="574984" y="265287"/>
            <a:ext cx="1440523" cy="1731498"/>
            <a:chOff x="530409" y="2067240"/>
            <a:chExt cx="1440523" cy="1731498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A0F8FDBE-5909-408E-466E-DF89BE707277}"/>
                </a:ext>
              </a:extLst>
            </p:cNvPr>
            <p:cNvGrpSpPr/>
            <p:nvPr/>
          </p:nvGrpSpPr>
          <p:grpSpPr>
            <a:xfrm>
              <a:off x="1123684" y="2067240"/>
              <a:ext cx="847248" cy="404244"/>
              <a:chOff x="7249416" y="915557"/>
              <a:chExt cx="847248" cy="404244"/>
            </a:xfrm>
          </p:grpSpPr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AD71B199-9945-9455-43D1-3F6C61AEE85F}"/>
                  </a:ext>
                </a:extLst>
              </p:cNvPr>
              <p:cNvSpPr txBox="1"/>
              <p:nvPr/>
            </p:nvSpPr>
            <p:spPr>
              <a:xfrm>
                <a:off x="7329950" y="915557"/>
                <a:ext cx="7667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BG</a:t>
                </a:r>
                <a:endParaRPr lang="zh-CN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id="{43893A7F-CEF2-98AD-0890-E1B12B9FE90D}"/>
                  </a:ext>
                </a:extLst>
              </p:cNvPr>
              <p:cNvGrpSpPr/>
              <p:nvPr/>
            </p:nvGrpSpPr>
            <p:grpSpPr>
              <a:xfrm>
                <a:off x="7249416" y="1065885"/>
                <a:ext cx="612000" cy="253916"/>
                <a:chOff x="7249416" y="1065885"/>
                <a:chExt cx="612000" cy="253916"/>
              </a:xfrm>
            </p:grpSpPr>
            <p:cxnSp>
              <p:nvCxnSpPr>
                <p:cNvPr id="33" name="直接连接符 32">
                  <a:extLst>
                    <a:ext uri="{FF2B5EF4-FFF2-40B4-BE49-F238E27FC236}">
                      <a16:creationId xmlns:a16="http://schemas.microsoft.com/office/drawing/2014/main" id="{58534AC5-1F43-6746-A216-C897518D8267}"/>
                    </a:ext>
                  </a:extLst>
                </p:cNvPr>
                <p:cNvCxnSpPr/>
                <p:nvPr/>
              </p:nvCxnSpPr>
              <p:spPr>
                <a:xfrm flipV="1">
                  <a:off x="7249416" y="1238627"/>
                  <a:ext cx="61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9EDA799B-B8F4-10EA-650B-CBE4C41A8C19}"/>
                    </a:ext>
                  </a:extLst>
                </p:cNvPr>
                <p:cNvSpPr txBox="1"/>
                <p:nvPr/>
              </p:nvSpPr>
              <p:spPr>
                <a:xfrm>
                  <a:off x="7372463" y="1065885"/>
                  <a:ext cx="426409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zh-CN" alt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</p:grp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582663BB-79E2-2866-C9C5-C9C0D16C81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766" t="13030" r="49581" b="12757"/>
            <a:stretch/>
          </p:blipFill>
          <p:spPr>
            <a:xfrm>
              <a:off x="753547" y="2358738"/>
              <a:ext cx="1171525" cy="1440000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D30842C-92F5-89F0-0A89-56F01DF47511}"/>
                </a:ext>
              </a:extLst>
            </p:cNvPr>
            <p:cNvSpPr txBox="1"/>
            <p:nvPr/>
          </p:nvSpPr>
          <p:spPr>
            <a:xfrm rot="16200000">
              <a:off x="-126130" y="2850737"/>
              <a:ext cx="1536216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5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  <a:endParaRPr lang="zh-CN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8161EFE4-3D18-67C0-8293-201831A56C19}"/>
              </a:ext>
            </a:extLst>
          </p:cNvPr>
          <p:cNvGrpSpPr/>
          <p:nvPr/>
        </p:nvGrpSpPr>
        <p:grpSpPr>
          <a:xfrm>
            <a:off x="1806301" y="639563"/>
            <a:ext cx="3838800" cy="1233906"/>
            <a:chOff x="4179317" y="479149"/>
            <a:chExt cx="3967201" cy="1233906"/>
          </a:xfrm>
        </p:grpSpPr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C72DF724-BD32-2847-A576-EB3068C44F8A}"/>
                </a:ext>
              </a:extLst>
            </p:cNvPr>
            <p:cNvSpPr/>
            <p:nvPr/>
          </p:nvSpPr>
          <p:spPr>
            <a:xfrm>
              <a:off x="5450708" y="479149"/>
              <a:ext cx="107593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s12a-VPR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94BB4EBD-9ABD-64A8-C620-6F67D526019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79317" y="669055"/>
              <a:ext cx="3967201" cy="1044000"/>
            </a:xfrm>
            <a:prstGeom prst="rect">
              <a:avLst/>
            </a:prstGeom>
          </p:spPr>
        </p:pic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1C9FCE8D-13B6-F907-ACFB-E25B63EA4241}"/>
              </a:ext>
            </a:extLst>
          </p:cNvPr>
          <p:cNvGrpSpPr/>
          <p:nvPr/>
        </p:nvGrpSpPr>
        <p:grpSpPr>
          <a:xfrm>
            <a:off x="4989618" y="630337"/>
            <a:ext cx="4154382" cy="1219536"/>
            <a:chOff x="369458" y="2436345"/>
            <a:chExt cx="4202542" cy="1219536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EF896A2C-92FA-62CD-88A7-05C474F26F7A}"/>
                </a:ext>
              </a:extLst>
            </p:cNvPr>
            <p:cNvSpPr/>
            <p:nvPr/>
          </p:nvSpPr>
          <p:spPr>
            <a:xfrm>
              <a:off x="1298437" y="2436345"/>
              <a:ext cx="1643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s12a-SunTag +VP64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46038948-4372-707A-A9DB-352DE35D820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9458" y="2611881"/>
              <a:ext cx="4202542" cy="1044000"/>
            </a:xfrm>
            <a:prstGeom prst="rect">
              <a:avLst/>
            </a:prstGeom>
          </p:spPr>
        </p:pic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F70AB72A-75DE-8A95-F709-49C1A02D36FC}"/>
              </a:ext>
            </a:extLst>
          </p:cNvPr>
          <p:cNvGrpSpPr/>
          <p:nvPr/>
        </p:nvGrpSpPr>
        <p:grpSpPr>
          <a:xfrm>
            <a:off x="1780273" y="2125210"/>
            <a:ext cx="4370643" cy="1232318"/>
            <a:chOff x="4341322" y="2379135"/>
            <a:chExt cx="4370643" cy="1232318"/>
          </a:xfrm>
        </p:grpSpPr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462F188B-181A-06EA-3FD3-B2D6F7C84317}"/>
                </a:ext>
              </a:extLst>
            </p:cNvPr>
            <p:cNvSpPr/>
            <p:nvPr/>
          </p:nvSpPr>
          <p:spPr>
            <a:xfrm>
              <a:off x="5538256" y="2379135"/>
              <a:ext cx="159851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s12a-SunTag +VPR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2123412D-62F5-5D89-3DA1-A74BE4D1754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341322" y="2567453"/>
              <a:ext cx="4370643" cy="1044000"/>
            </a:xfrm>
            <a:prstGeom prst="rect">
              <a:avLst/>
            </a:prstGeom>
          </p:spPr>
        </p:pic>
      </p:grpSp>
      <p:sp>
        <p:nvSpPr>
          <p:cNvPr id="11" name="矩形 10">
            <a:extLst>
              <a:ext uri="{FF2B5EF4-FFF2-40B4-BE49-F238E27FC236}">
                <a16:creationId xmlns:a16="http://schemas.microsoft.com/office/drawing/2014/main" id="{6013C8E9-5321-96BC-46D7-E9EB677470EB}"/>
              </a:ext>
            </a:extLst>
          </p:cNvPr>
          <p:cNvSpPr/>
          <p:nvPr/>
        </p:nvSpPr>
        <p:spPr>
          <a:xfrm>
            <a:off x="857643" y="100749"/>
            <a:ext cx="104111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as12a-VPR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9794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1C15534-DBF3-61B1-B4CE-D13B8D65A749}"/>
              </a:ext>
            </a:extLst>
          </p:cNvPr>
          <p:cNvSpPr txBox="1"/>
          <p:nvPr/>
        </p:nvSpPr>
        <p:spPr>
          <a:xfrm>
            <a:off x="660728" y="1706817"/>
            <a:ext cx="7952331" cy="26432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2 Circular gRNAs increase the transcription efficiency of 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based activators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directed gene activation in MCF7 cell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Western blot of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based activator proteins in transfected HEK293T cell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he specificity of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gRN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directed gene activation showed with volcano plot. DEG, Differentially Expressed Genes.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q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Fold change &gt;2. For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quantitative RT-PCR revealed relative mRNA expression of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IL1R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BG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Mean values are presented with S.D., n = 3 independent experiments. For each experiment, fold changes of mRNA expression in tested samples versus that in the U6 + 27 linear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gRNA were shown. 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5, 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1, ***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lt;0.001, one-way ANOVA test.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5003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矩形 14"/>
          <p:cNvSpPr/>
          <p:nvPr/>
        </p:nvSpPr>
        <p:spPr>
          <a:xfrm>
            <a:off x="0" y="5867015"/>
            <a:ext cx="903998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3 Establishment of the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 knock-in HEK293T cell line and off-target analysis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 with different gRNAs. 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3483558" y="15833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7834" y="165310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505927" y="1750611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3B0EFE-0644-F086-EAA9-B1C09576291D}"/>
              </a:ext>
            </a:extLst>
          </p:cNvPr>
          <p:cNvSpPr txBox="1"/>
          <p:nvPr/>
        </p:nvSpPr>
        <p:spPr>
          <a:xfrm>
            <a:off x="195465" y="19494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4B0A99AA-181B-16FA-6C83-6C90D3496FF5}"/>
              </a:ext>
            </a:extLst>
          </p:cNvPr>
          <p:cNvSpPr/>
          <p:nvPr/>
        </p:nvSpPr>
        <p:spPr>
          <a:xfrm>
            <a:off x="1353958" y="415021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as12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638A34FB-377B-F1FE-7C36-A14529D538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9117" y="541979"/>
            <a:ext cx="4972367" cy="1107240"/>
          </a:xfrm>
          <a:prstGeom prst="rect">
            <a:avLst/>
          </a:prstGeom>
        </p:spPr>
      </p:pic>
      <p:grpSp>
        <p:nvGrpSpPr>
          <p:cNvPr id="32" name="组合 31">
            <a:extLst>
              <a:ext uri="{FF2B5EF4-FFF2-40B4-BE49-F238E27FC236}">
                <a16:creationId xmlns:a16="http://schemas.microsoft.com/office/drawing/2014/main" id="{CE966D2F-201C-DF09-9768-226320D7C09E}"/>
              </a:ext>
            </a:extLst>
          </p:cNvPr>
          <p:cNvGrpSpPr/>
          <p:nvPr/>
        </p:nvGrpSpPr>
        <p:grpSpPr>
          <a:xfrm>
            <a:off x="4388381" y="1859058"/>
            <a:ext cx="3075766" cy="1266039"/>
            <a:chOff x="2526571" y="2602131"/>
            <a:chExt cx="3075766" cy="126603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/>
            <a:srcRect l="23898" t="41972" r="38716" b="-1"/>
            <a:stretch/>
          </p:blipFill>
          <p:spPr>
            <a:xfrm>
              <a:off x="3576556" y="3030575"/>
              <a:ext cx="1222828" cy="837595"/>
            </a:xfrm>
            <a:prstGeom prst="rect">
              <a:avLst/>
            </a:prstGeom>
          </p:spPr>
        </p:pic>
        <p:sp>
          <p:nvSpPr>
            <p:cNvPr id="25" name="文本框 24"/>
            <p:cNvSpPr txBox="1"/>
            <p:nvPr/>
          </p:nvSpPr>
          <p:spPr>
            <a:xfrm>
              <a:off x="2526571" y="3151713"/>
              <a:ext cx="13060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α-HA</a:t>
              </a: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717154" y="3548286"/>
              <a:ext cx="9249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907267" y="3183142"/>
              <a:ext cx="6786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143KD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接箭头连接符 27"/>
            <p:cNvCxnSpPr/>
            <p:nvPr/>
          </p:nvCxnSpPr>
          <p:spPr>
            <a:xfrm flipH="1">
              <a:off x="4850222" y="3310100"/>
              <a:ext cx="72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4923676" y="3518685"/>
              <a:ext cx="6786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55KD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箭头连接符 29"/>
            <p:cNvCxnSpPr/>
            <p:nvPr/>
          </p:nvCxnSpPr>
          <p:spPr>
            <a:xfrm flipH="1">
              <a:off x="4866631" y="3645643"/>
              <a:ext cx="72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" name="文本框 1"/>
            <p:cNvSpPr txBox="1"/>
            <p:nvPr/>
          </p:nvSpPr>
          <p:spPr>
            <a:xfrm>
              <a:off x="3589766" y="2916616"/>
              <a:ext cx="12841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-DOX        +DOX 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6F35B9CE-3F0C-1AA7-E68E-7E653065A10B}"/>
                </a:ext>
              </a:extLst>
            </p:cNvPr>
            <p:cNvSpPr/>
            <p:nvPr/>
          </p:nvSpPr>
          <p:spPr>
            <a:xfrm>
              <a:off x="3776639" y="2602131"/>
              <a:ext cx="78739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12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1" name="图片 30">
            <a:extLst>
              <a:ext uri="{FF2B5EF4-FFF2-40B4-BE49-F238E27FC236}">
                <a16:creationId xmlns:a16="http://schemas.microsoft.com/office/drawing/2014/main" id="{FCAC826D-51A2-FD04-C4AB-EE6ECC7EE9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702" y="714802"/>
            <a:ext cx="3812235" cy="876232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A0D05A73-FB0E-9482-937D-73AA13A9C0EE}"/>
              </a:ext>
            </a:extLst>
          </p:cNvPr>
          <p:cNvSpPr txBox="1"/>
          <p:nvPr/>
        </p:nvSpPr>
        <p:spPr>
          <a:xfrm>
            <a:off x="292634" y="351772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D8367459-14FE-A057-DE28-F00849CB09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7566" y="1791606"/>
            <a:ext cx="1642360" cy="1789194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98E1E1C0-EACF-F657-8266-C6678857261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6336" t="16295" b="49735"/>
          <a:stretch/>
        </p:blipFill>
        <p:spPr>
          <a:xfrm>
            <a:off x="7997302" y="4009523"/>
            <a:ext cx="664182" cy="738277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6169066E-82EA-0A82-9E16-54914B5433E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411" r="39874" b="13996"/>
          <a:stretch/>
        </p:blipFill>
        <p:spPr>
          <a:xfrm>
            <a:off x="371509" y="3962615"/>
            <a:ext cx="1812036" cy="1764000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FB605780-CE3F-8EFD-D6B8-16D25D8E784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673" r="25438" b="5926"/>
          <a:stretch/>
        </p:blipFill>
        <p:spPr>
          <a:xfrm>
            <a:off x="2136051" y="3962615"/>
            <a:ext cx="2648098" cy="176400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44B80A8B-ED34-9664-3F39-5A9A4844B50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3174" r="52212" b="5886"/>
          <a:stretch/>
        </p:blipFill>
        <p:spPr>
          <a:xfrm>
            <a:off x="4719594" y="3962615"/>
            <a:ext cx="1693671" cy="17640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F9C2C5C9-1B85-F22C-7114-B252B29D506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4447" r="53286" b="6630"/>
          <a:stretch/>
        </p:blipFill>
        <p:spPr>
          <a:xfrm>
            <a:off x="6368186" y="3962615"/>
            <a:ext cx="1669677" cy="17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006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6867481-DE65-CCF3-BB04-7FFB9FF05C94}"/>
              </a:ext>
            </a:extLst>
          </p:cNvPr>
          <p:cNvSpPr txBox="1"/>
          <p:nvPr/>
        </p:nvSpPr>
        <p:spPr>
          <a:xfrm>
            <a:off x="471949" y="1056617"/>
            <a:ext cx="8093914" cy="26432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3 Establishment of the 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knock-in HEK293T cell line and off-target analysis of 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with different gRNAs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Western blot of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proteins in transfected </a:t>
            </a:r>
            <a:r>
              <a:rPr lang="en-US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NeonGreen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orter cell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Schematic of the DNA donor and targeting strategy at the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AVS1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locus. The strategy is as same as the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KI cell line except replacing the coding sequence of 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-p300 with the one of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&amp;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he inducible expression of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in the KI cell line was confirmed by quantitative RT-PCR and Western Blotting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he sequencing read counts of off-target sites by Tag-seq.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knock-in HEK293T cells transfected with 14 gRNAs, and genomic DNA was extracted after 4 days post transfection. OT, off-targe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27364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/>
        </p:nvSpPr>
        <p:spPr>
          <a:xfrm>
            <a:off x="7186579" y="4138397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" name="矩形 14"/>
          <p:cNvSpPr/>
          <p:nvPr/>
        </p:nvSpPr>
        <p:spPr>
          <a:xfrm>
            <a:off x="52006" y="6247094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 Circular gRNAs improve the DNA cleavage efficiency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s12a in MCF7 cells.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318501" y="113659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186579" y="113659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186579" y="2055290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9D47A54-7CFB-E642-48BE-4173FCD472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0075" y="134565"/>
            <a:ext cx="1386087" cy="179843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A8F4ED2-0618-C10B-0C52-34E4B66283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30075" y="2130402"/>
            <a:ext cx="1563687" cy="194292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0BC2687-2AA6-D965-647C-21A2B13DDB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30075" y="4270724"/>
            <a:ext cx="1402199" cy="1827256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981DA4E-544B-2B9C-90B8-22A196872345}"/>
              </a:ext>
            </a:extLst>
          </p:cNvPr>
          <p:cNvSpPr txBox="1"/>
          <p:nvPr/>
        </p:nvSpPr>
        <p:spPr>
          <a:xfrm>
            <a:off x="318500" y="3425592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3328FDCD-1A93-B644-185F-C1864519A79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9831" t="9748" b="61202"/>
          <a:stretch/>
        </p:blipFill>
        <p:spPr>
          <a:xfrm>
            <a:off x="6634264" y="3681809"/>
            <a:ext cx="544749" cy="409972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0549E41-D0D4-286D-98D5-336904F3BE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5005" y="273480"/>
            <a:ext cx="6234811" cy="324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434A607-8E1C-2619-CD9F-722D1A81330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1726" y="3714188"/>
            <a:ext cx="6621355" cy="24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66968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29BB4500-DA3A-AE99-14BF-44F7F23255D4}"/>
              </a:ext>
            </a:extLst>
          </p:cNvPr>
          <p:cNvSpPr txBox="1"/>
          <p:nvPr/>
        </p:nvSpPr>
        <p:spPr>
          <a:xfrm>
            <a:off x="401156" y="1378997"/>
            <a:ext cx="8170606" cy="23201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. S4 Circular gRNAs improve the DNA cleavage efficiency of </a:t>
            </a:r>
            <a:r>
              <a:rPr lang="en-US" altLang="zh-CN" sz="14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Lb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 in MCF7 cells. a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Editing reads at the on-target and off-target sites revealed by Tag-seq in MCF7 cells targeting as the same 14 sites as in HEK293T cell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he sequencing read counts of off-target sites by Tag-seq. OT, off-target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,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Efficiency comparison between different gRNAs.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Global on-target cleavage specificity assessment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Total number of off-target sites detected for the 14 sites. For 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-e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, MCF7 cells were co-transfected with plasmids encoding 14 gRNAs in the form of U6 + 27, or Pre, or C-L7 and</a:t>
            </a:r>
            <a:r>
              <a:rPr lang="en-US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Lb</a:t>
            </a:r>
            <a:r>
              <a:rPr lang="en-US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12a, and 4 days later, the genomic DNA was harvested for Tag-seq analysis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81380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E82612C8-F07D-FBDD-470B-0FC25AB01573}"/>
              </a:ext>
            </a:extLst>
          </p:cNvPr>
          <p:cNvSpPr txBox="1"/>
          <p:nvPr/>
        </p:nvSpPr>
        <p:spPr>
          <a:xfrm>
            <a:off x="1111311" y="83516"/>
            <a:ext cx="7667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DC4A6E7-852C-D2BF-B83F-1260504B4C75}"/>
              </a:ext>
            </a:extLst>
          </p:cNvPr>
          <p:cNvSpPr txBox="1"/>
          <p:nvPr/>
        </p:nvSpPr>
        <p:spPr>
          <a:xfrm rot="16200000">
            <a:off x="-506873" y="907204"/>
            <a:ext cx="16454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8C1720C-C139-6B02-2545-D34C38121E17}"/>
              </a:ext>
            </a:extLst>
          </p:cNvPr>
          <p:cNvSpPr txBox="1"/>
          <p:nvPr/>
        </p:nvSpPr>
        <p:spPr>
          <a:xfrm>
            <a:off x="1169698" y="1931859"/>
            <a:ext cx="76671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HBG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D5D8194-562D-F146-E4AD-28D68798770A}"/>
              </a:ext>
            </a:extLst>
          </p:cNvPr>
          <p:cNvSpPr txBox="1"/>
          <p:nvPr/>
        </p:nvSpPr>
        <p:spPr>
          <a:xfrm rot="16200000">
            <a:off x="-549205" y="2717026"/>
            <a:ext cx="1724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9C924D3-D551-9C6B-77E6-C19FE20F5D1E}"/>
              </a:ext>
            </a:extLst>
          </p:cNvPr>
          <p:cNvSpPr txBox="1"/>
          <p:nvPr/>
        </p:nvSpPr>
        <p:spPr>
          <a:xfrm>
            <a:off x="21100" y="-3479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2E52898-ECCF-692C-8AB6-B25158F1F8FE}"/>
              </a:ext>
            </a:extLst>
          </p:cNvPr>
          <p:cNvSpPr txBox="1"/>
          <p:nvPr/>
        </p:nvSpPr>
        <p:spPr>
          <a:xfrm>
            <a:off x="2392527" y="-3479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4456DE2-27AB-BEFB-9DAC-9F121716F1FC}"/>
              </a:ext>
            </a:extLst>
          </p:cNvPr>
          <p:cNvSpPr txBox="1"/>
          <p:nvPr/>
        </p:nvSpPr>
        <p:spPr>
          <a:xfrm>
            <a:off x="6274328" y="-34798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C171D94-B734-E4C8-1C73-029B8288D961}"/>
              </a:ext>
            </a:extLst>
          </p:cNvPr>
          <p:cNvSpPr txBox="1"/>
          <p:nvPr/>
        </p:nvSpPr>
        <p:spPr>
          <a:xfrm>
            <a:off x="61047" y="3889214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19F9D11-97DC-F9D7-2C31-2D09DC70E7B7}"/>
              </a:ext>
            </a:extLst>
          </p:cNvPr>
          <p:cNvSpPr txBox="1"/>
          <p:nvPr/>
        </p:nvSpPr>
        <p:spPr>
          <a:xfrm>
            <a:off x="6336673" y="3851114"/>
            <a:ext cx="366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3D9BA0F6-D662-6F88-03AE-79848F22B88A}"/>
              </a:ext>
            </a:extLst>
          </p:cNvPr>
          <p:cNvSpPr/>
          <p:nvPr/>
        </p:nvSpPr>
        <p:spPr>
          <a:xfrm>
            <a:off x="61047" y="6265832"/>
            <a:ext cx="90399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5 comparison between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RNA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with other extended structuralized gRNAs. 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49C034C-9460-FF8D-3BD8-2F50D6A4033A}"/>
              </a:ext>
            </a:extLst>
          </p:cNvPr>
          <p:cNvSpPr txBox="1"/>
          <p:nvPr/>
        </p:nvSpPr>
        <p:spPr>
          <a:xfrm>
            <a:off x="7254914" y="3883911"/>
            <a:ext cx="1179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VEGFA-S1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613F77A-A4C5-C844-65AE-3F7F92CDEF18}"/>
              </a:ext>
            </a:extLst>
          </p:cNvPr>
          <p:cNvSpPr txBox="1"/>
          <p:nvPr/>
        </p:nvSpPr>
        <p:spPr>
          <a:xfrm>
            <a:off x="2528158" y="3927540"/>
            <a:ext cx="12209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VEGFA-S1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5E5D36EA-7FCB-ECE8-9180-2165533C20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3302" y="199889"/>
            <a:ext cx="3608816" cy="351252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C4630415-39C9-F364-5337-30D2BD5E0F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042" y="4125948"/>
            <a:ext cx="6045631" cy="21096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195931D-3E05-5EFC-81FD-649D0F23089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5047" y="4096750"/>
            <a:ext cx="2387782" cy="206217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2709275-F3D7-9318-9142-C35CC1D6DA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58978" y="770584"/>
            <a:ext cx="2624138" cy="224033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805727A-56CA-8F2A-D9EC-5ABC2AE6A9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7426" y="250802"/>
            <a:ext cx="1692000" cy="165077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47C309C-2CFA-60BD-89AB-26FBCAD3ED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7479" y="2118692"/>
            <a:ext cx="1692000" cy="1700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5109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3</TotalTime>
  <Words>2328</Words>
  <Application>Microsoft Office PowerPoint</Application>
  <PresentationFormat>全屏显示(4:3)</PresentationFormat>
  <Paragraphs>315</Paragraphs>
  <Slides>26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6</vt:i4>
      </vt:variant>
    </vt:vector>
  </HeadingPairs>
  <TitlesOfParts>
    <vt:vector size="31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hlW</dc:creator>
  <cp:lastModifiedBy>张 鑫</cp:lastModifiedBy>
  <cp:revision>95</cp:revision>
  <dcterms:created xsi:type="dcterms:W3CDTF">2022-04-02T06:08:37Z</dcterms:created>
  <dcterms:modified xsi:type="dcterms:W3CDTF">2023-06-01T03:48:25Z</dcterms:modified>
</cp:coreProperties>
</file>